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2496" y="-12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50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34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384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55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38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47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6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9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08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3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01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A9562-35E4-4044-AB91-1245C992B1CB}" type="datetimeFigureOut">
              <a:rPr lang="en-US" smtClean="0"/>
              <a:t>10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98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tiff"/><Relationship Id="rId12" Type="http://schemas.openxmlformats.org/officeDocument/2006/relationships/image" Target="../media/image11.tiff"/><Relationship Id="rId13" Type="http://schemas.openxmlformats.org/officeDocument/2006/relationships/image" Target="../media/image12.tiff"/><Relationship Id="rId14" Type="http://schemas.openxmlformats.org/officeDocument/2006/relationships/image" Target="../media/image13.tiff"/><Relationship Id="rId15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f"/><Relationship Id="rId10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842" b="15817"/>
          <a:stretch/>
        </p:blipFill>
        <p:spPr>
          <a:xfrm>
            <a:off x="3307402" y="5602395"/>
            <a:ext cx="1602900" cy="1111443"/>
          </a:xfrm>
          <a:prstGeom prst="rect">
            <a:avLst/>
          </a:prstGeom>
        </p:spPr>
      </p:pic>
      <p:sp>
        <p:nvSpPr>
          <p:cNvPr id="5" name="Rectangle 38"/>
          <p:cNvSpPr>
            <a:spLocks noChangeArrowheads="1"/>
          </p:cNvSpPr>
          <p:nvPr/>
        </p:nvSpPr>
        <p:spPr bwMode="auto">
          <a:xfrm>
            <a:off x="302468" y="381000"/>
            <a:ext cx="74396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S6</a:t>
            </a:r>
            <a:r>
              <a:rPr kumimoji="0" lang="en-US" sz="12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Figure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12742" y="1930802"/>
            <a:ext cx="13478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HEK293T </a:t>
            </a:r>
          </a:p>
          <a:p>
            <a:r>
              <a:rPr lang="fr-FR" sz="1200" dirty="0" smtClean="0">
                <a:latin typeface="Arial"/>
                <a:cs typeface="Arial"/>
              </a:rPr>
              <a:t>pcDNA3.1 </a:t>
            </a:r>
            <a:r>
              <a:rPr lang="fr-FR" sz="1200" dirty="0" err="1" smtClean="0">
                <a:latin typeface="Arial"/>
                <a:cs typeface="Arial"/>
              </a:rPr>
              <a:t>empty</a:t>
            </a:r>
            <a:endParaRPr lang="fr-FR" sz="1200" dirty="0">
              <a:latin typeface="Arial"/>
              <a:cs typeface="Arial"/>
            </a:endParaRPr>
          </a:p>
          <a:p>
            <a:r>
              <a:rPr lang="fr-FR" sz="1200" dirty="0" smtClean="0">
                <a:latin typeface="Arial"/>
                <a:cs typeface="Arial"/>
              </a:rPr>
              <a:t>IF anti-DSTN</a:t>
            </a:r>
            <a:endParaRPr lang="fr-FR" sz="1200" dirty="0">
              <a:latin typeface="Arial"/>
              <a:cs typeface="Arial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771" b="8642"/>
          <a:stretch/>
        </p:blipFill>
        <p:spPr>
          <a:xfrm>
            <a:off x="1660845" y="3136765"/>
            <a:ext cx="1593799" cy="112723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511" r="23759" b="7908"/>
          <a:stretch/>
        </p:blipFill>
        <p:spPr>
          <a:xfrm>
            <a:off x="3307403" y="1955935"/>
            <a:ext cx="1594056" cy="112758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23770" b="7190"/>
          <a:stretch/>
        </p:blipFill>
        <p:spPr>
          <a:xfrm>
            <a:off x="1660845" y="1955935"/>
            <a:ext cx="1593799" cy="113011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23760" b="8138"/>
          <a:stretch/>
        </p:blipFill>
        <p:spPr>
          <a:xfrm>
            <a:off x="3307402" y="765890"/>
            <a:ext cx="1594057" cy="113344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r="23771" b="7947"/>
          <a:stretch/>
        </p:blipFill>
        <p:spPr>
          <a:xfrm>
            <a:off x="1660846" y="765890"/>
            <a:ext cx="1593798" cy="1135806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572201" y="539760"/>
            <a:ext cx="1005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B050"/>
                </a:solidFill>
                <a:latin typeface="Arial"/>
                <a:cs typeface="Arial"/>
              </a:rPr>
              <a:t>DSTN</a:t>
            </a:r>
            <a:r>
              <a:rPr lang="fr-FR" sz="1200" dirty="0" smtClean="0">
                <a:latin typeface="Arial"/>
                <a:cs typeface="Arial"/>
              </a:rPr>
              <a:t> </a:t>
            </a:r>
            <a:r>
              <a:rPr lang="fr-FR" sz="1200" dirty="0" smtClean="0">
                <a:solidFill>
                  <a:srgbClr val="0000FF"/>
                </a:solidFill>
                <a:latin typeface="Arial"/>
                <a:cs typeface="Arial"/>
              </a:rPr>
              <a:t>DAPI</a:t>
            </a:r>
            <a:endParaRPr lang="fr-FR" sz="1200" dirty="0">
              <a:solidFill>
                <a:srgbClr val="0000FF"/>
              </a:solidFill>
              <a:latin typeface="Arial"/>
              <a:cs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759" b="8642"/>
          <a:stretch/>
        </p:blipFill>
        <p:spPr>
          <a:xfrm>
            <a:off x="3307402" y="3136763"/>
            <a:ext cx="1594056" cy="1127231"/>
          </a:xfrm>
          <a:prstGeom prst="rect">
            <a:avLst/>
          </a:prstGeom>
        </p:spPr>
      </p:pic>
      <p:cxnSp>
        <p:nvCxnSpPr>
          <p:cNvPr id="17" name="Straight Connector 16"/>
          <p:cNvCxnSpPr/>
          <p:nvPr/>
        </p:nvCxnSpPr>
        <p:spPr>
          <a:xfrm>
            <a:off x="4678756" y="4229723"/>
            <a:ext cx="194926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417991" y="4015103"/>
            <a:ext cx="672794" cy="2896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220778" y="539760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B050"/>
                </a:solidFill>
                <a:latin typeface="Arial"/>
                <a:cs typeface="Arial"/>
              </a:rPr>
              <a:t>DSTN</a:t>
            </a:r>
            <a:endParaRPr lang="fr-FR" sz="1200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2742" y="732709"/>
            <a:ext cx="14332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HEK293T </a:t>
            </a:r>
          </a:p>
          <a:p>
            <a:r>
              <a:rPr lang="fr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cDNA3.1/hDSTN</a:t>
            </a:r>
            <a:endParaRPr lang="fr-FR" sz="1200" dirty="0">
              <a:latin typeface="Arial"/>
              <a:cs typeface="Arial"/>
            </a:endParaRPr>
          </a:p>
          <a:p>
            <a:r>
              <a:rPr lang="fr-FR" sz="1200" dirty="0" smtClean="0">
                <a:latin typeface="Arial"/>
                <a:cs typeface="Arial"/>
              </a:rPr>
              <a:t>IF anti-DSTN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12742" y="3103232"/>
            <a:ext cx="14332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HEK293T </a:t>
            </a:r>
          </a:p>
          <a:p>
            <a:r>
              <a:rPr lang="fr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cDNA3.1</a:t>
            </a:r>
            <a:r>
              <a:rPr lang="fr-CH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DSTN</a:t>
            </a:r>
          </a:p>
          <a:p>
            <a:r>
              <a:rPr lang="fr-FR" sz="1200" dirty="0" smtClean="0">
                <a:latin typeface="Arial"/>
                <a:cs typeface="Arial"/>
              </a:rPr>
              <a:t>no first Ab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9" name="Rectangle 38"/>
          <p:cNvSpPr>
            <a:spLocks noChangeArrowheads="1"/>
          </p:cNvSpPr>
          <p:nvPr/>
        </p:nvSpPr>
        <p:spPr bwMode="auto">
          <a:xfrm>
            <a:off x="323016" y="593953"/>
            <a:ext cx="1481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A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26" name="Rectangle 38"/>
          <p:cNvSpPr>
            <a:spLocks noChangeArrowheads="1"/>
          </p:cNvSpPr>
          <p:nvPr/>
        </p:nvSpPr>
        <p:spPr bwMode="auto">
          <a:xfrm>
            <a:off x="343564" y="6750671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C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27" name="Rectangle 38"/>
          <p:cNvSpPr>
            <a:spLocks noChangeArrowheads="1"/>
          </p:cNvSpPr>
          <p:nvPr/>
        </p:nvSpPr>
        <p:spPr bwMode="auto">
          <a:xfrm>
            <a:off x="343564" y="4282402"/>
            <a:ext cx="11113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B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2742" y="4389095"/>
            <a:ext cx="10824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 anti-DST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12742" y="5552858"/>
            <a:ext cx="89434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 first 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12742" y="6838893"/>
            <a:ext cx="10824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F anti-DST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12742" y="8128614"/>
            <a:ext cx="11769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</a:p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typ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58" b="5180"/>
          <a:stretch/>
        </p:blipFill>
        <p:spPr>
          <a:xfrm>
            <a:off x="3317913" y="8150982"/>
            <a:ext cx="1602168" cy="1202974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98" b="4942"/>
          <a:stretch/>
        </p:blipFill>
        <p:spPr>
          <a:xfrm>
            <a:off x="1652474" y="8150982"/>
            <a:ext cx="1602169" cy="120297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31" b="3508"/>
          <a:stretch/>
        </p:blipFill>
        <p:spPr>
          <a:xfrm>
            <a:off x="3321352" y="6884671"/>
            <a:ext cx="1602169" cy="120297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4" b="4356"/>
          <a:stretch/>
        </p:blipFill>
        <p:spPr>
          <a:xfrm>
            <a:off x="1652475" y="6873609"/>
            <a:ext cx="1602169" cy="1202975"/>
          </a:xfrm>
          <a:prstGeom prst="rect">
            <a:avLst/>
          </a:prstGeom>
        </p:spPr>
      </p:pic>
      <p:cxnSp>
        <p:nvCxnSpPr>
          <p:cNvPr id="32" name="Straight Connector 31"/>
          <p:cNvCxnSpPr/>
          <p:nvPr/>
        </p:nvCxnSpPr>
        <p:spPr>
          <a:xfrm>
            <a:off x="4729682" y="9308855"/>
            <a:ext cx="144000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417561" y="9092346"/>
            <a:ext cx="672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/>
          <p:cNvCxnSpPr/>
          <p:nvPr/>
        </p:nvCxnSpPr>
        <p:spPr>
          <a:xfrm>
            <a:off x="4729682" y="6683293"/>
            <a:ext cx="143832" cy="1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439822" y="6467440"/>
            <a:ext cx="672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11" b="15308"/>
          <a:stretch/>
        </p:blipFill>
        <p:spPr>
          <a:xfrm>
            <a:off x="1660884" y="5601737"/>
            <a:ext cx="1593759" cy="1112101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19" b="14167"/>
          <a:stretch/>
        </p:blipFill>
        <p:spPr>
          <a:xfrm>
            <a:off x="1660846" y="4431320"/>
            <a:ext cx="1590656" cy="1112100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600" b="13669"/>
          <a:stretch/>
        </p:blipFill>
        <p:spPr>
          <a:xfrm>
            <a:off x="3307402" y="4441743"/>
            <a:ext cx="1594056" cy="1111540"/>
          </a:xfrm>
          <a:prstGeom prst="rect">
            <a:avLst/>
          </a:prstGeom>
        </p:spPr>
      </p:pic>
      <p:sp>
        <p:nvSpPr>
          <p:cNvPr id="14" name="Freeform 13"/>
          <p:cNvSpPr/>
          <p:nvPr/>
        </p:nvSpPr>
        <p:spPr>
          <a:xfrm>
            <a:off x="1654175" y="7486649"/>
            <a:ext cx="1597025" cy="555626"/>
          </a:xfrm>
          <a:custGeom>
            <a:avLst/>
            <a:gdLst>
              <a:gd name="connsiteX0" fmla="*/ 0 w 1597025"/>
              <a:gd name="connsiteY0" fmla="*/ 6351 h 555626"/>
              <a:gd name="connsiteX1" fmla="*/ 15875 w 1597025"/>
              <a:gd name="connsiteY1" fmla="*/ 15876 h 555626"/>
              <a:gd name="connsiteX2" fmla="*/ 25400 w 1597025"/>
              <a:gd name="connsiteY2" fmla="*/ 19051 h 555626"/>
              <a:gd name="connsiteX3" fmla="*/ 53975 w 1597025"/>
              <a:gd name="connsiteY3" fmla="*/ 38101 h 555626"/>
              <a:gd name="connsiteX4" fmla="*/ 63500 w 1597025"/>
              <a:gd name="connsiteY4" fmla="*/ 44451 h 555626"/>
              <a:gd name="connsiteX5" fmla="*/ 82550 w 1597025"/>
              <a:gd name="connsiteY5" fmla="*/ 50801 h 555626"/>
              <a:gd name="connsiteX6" fmla="*/ 92075 w 1597025"/>
              <a:gd name="connsiteY6" fmla="*/ 57151 h 555626"/>
              <a:gd name="connsiteX7" fmla="*/ 111125 w 1597025"/>
              <a:gd name="connsiteY7" fmla="*/ 63501 h 555626"/>
              <a:gd name="connsiteX8" fmla="*/ 130175 w 1597025"/>
              <a:gd name="connsiteY8" fmla="*/ 76201 h 555626"/>
              <a:gd name="connsiteX9" fmla="*/ 149225 w 1597025"/>
              <a:gd name="connsiteY9" fmla="*/ 82551 h 555626"/>
              <a:gd name="connsiteX10" fmla="*/ 158750 w 1597025"/>
              <a:gd name="connsiteY10" fmla="*/ 85726 h 555626"/>
              <a:gd name="connsiteX11" fmla="*/ 190500 w 1597025"/>
              <a:gd name="connsiteY11" fmla="*/ 92076 h 555626"/>
              <a:gd name="connsiteX12" fmla="*/ 203200 w 1597025"/>
              <a:gd name="connsiteY12" fmla="*/ 95251 h 555626"/>
              <a:gd name="connsiteX13" fmla="*/ 266700 w 1597025"/>
              <a:gd name="connsiteY13" fmla="*/ 101601 h 555626"/>
              <a:gd name="connsiteX14" fmla="*/ 276225 w 1597025"/>
              <a:gd name="connsiteY14" fmla="*/ 107951 h 555626"/>
              <a:gd name="connsiteX15" fmla="*/ 285750 w 1597025"/>
              <a:gd name="connsiteY15" fmla="*/ 127001 h 555626"/>
              <a:gd name="connsiteX16" fmla="*/ 292100 w 1597025"/>
              <a:gd name="connsiteY16" fmla="*/ 136526 h 555626"/>
              <a:gd name="connsiteX17" fmla="*/ 298450 w 1597025"/>
              <a:gd name="connsiteY17" fmla="*/ 155576 h 555626"/>
              <a:gd name="connsiteX18" fmla="*/ 317500 w 1597025"/>
              <a:gd name="connsiteY18" fmla="*/ 168276 h 555626"/>
              <a:gd name="connsiteX19" fmla="*/ 327025 w 1597025"/>
              <a:gd name="connsiteY19" fmla="*/ 174626 h 555626"/>
              <a:gd name="connsiteX20" fmla="*/ 336550 w 1597025"/>
              <a:gd name="connsiteY20" fmla="*/ 177801 h 555626"/>
              <a:gd name="connsiteX21" fmla="*/ 346075 w 1597025"/>
              <a:gd name="connsiteY21" fmla="*/ 184151 h 555626"/>
              <a:gd name="connsiteX22" fmla="*/ 365125 w 1597025"/>
              <a:gd name="connsiteY22" fmla="*/ 190501 h 555626"/>
              <a:gd name="connsiteX23" fmla="*/ 393700 w 1597025"/>
              <a:gd name="connsiteY23" fmla="*/ 203201 h 555626"/>
              <a:gd name="connsiteX24" fmla="*/ 444500 w 1597025"/>
              <a:gd name="connsiteY24" fmla="*/ 212726 h 555626"/>
              <a:gd name="connsiteX25" fmla="*/ 466725 w 1597025"/>
              <a:gd name="connsiteY25" fmla="*/ 215901 h 555626"/>
              <a:gd name="connsiteX26" fmla="*/ 508000 w 1597025"/>
              <a:gd name="connsiteY26" fmla="*/ 222251 h 555626"/>
              <a:gd name="connsiteX27" fmla="*/ 527050 w 1597025"/>
              <a:gd name="connsiteY27" fmla="*/ 228601 h 555626"/>
              <a:gd name="connsiteX28" fmla="*/ 536575 w 1597025"/>
              <a:gd name="connsiteY28" fmla="*/ 231776 h 555626"/>
              <a:gd name="connsiteX29" fmla="*/ 555625 w 1597025"/>
              <a:gd name="connsiteY29" fmla="*/ 241301 h 555626"/>
              <a:gd name="connsiteX30" fmla="*/ 565150 w 1597025"/>
              <a:gd name="connsiteY30" fmla="*/ 247651 h 555626"/>
              <a:gd name="connsiteX31" fmla="*/ 584200 w 1597025"/>
              <a:gd name="connsiteY31" fmla="*/ 254001 h 555626"/>
              <a:gd name="connsiteX32" fmla="*/ 593725 w 1597025"/>
              <a:gd name="connsiteY32" fmla="*/ 257176 h 555626"/>
              <a:gd name="connsiteX33" fmla="*/ 612775 w 1597025"/>
              <a:gd name="connsiteY33" fmla="*/ 269876 h 555626"/>
              <a:gd name="connsiteX34" fmla="*/ 619125 w 1597025"/>
              <a:gd name="connsiteY34" fmla="*/ 279401 h 555626"/>
              <a:gd name="connsiteX35" fmla="*/ 628650 w 1597025"/>
              <a:gd name="connsiteY35" fmla="*/ 282576 h 555626"/>
              <a:gd name="connsiteX36" fmla="*/ 638175 w 1597025"/>
              <a:gd name="connsiteY36" fmla="*/ 288926 h 555626"/>
              <a:gd name="connsiteX37" fmla="*/ 644525 w 1597025"/>
              <a:gd name="connsiteY37" fmla="*/ 298451 h 555626"/>
              <a:gd name="connsiteX38" fmla="*/ 654050 w 1597025"/>
              <a:gd name="connsiteY38" fmla="*/ 307976 h 555626"/>
              <a:gd name="connsiteX39" fmla="*/ 657225 w 1597025"/>
              <a:gd name="connsiteY39" fmla="*/ 317501 h 555626"/>
              <a:gd name="connsiteX40" fmla="*/ 663575 w 1597025"/>
              <a:gd name="connsiteY40" fmla="*/ 327026 h 555626"/>
              <a:gd name="connsiteX41" fmla="*/ 666750 w 1597025"/>
              <a:gd name="connsiteY41" fmla="*/ 393701 h 555626"/>
              <a:gd name="connsiteX42" fmla="*/ 669925 w 1597025"/>
              <a:gd name="connsiteY42" fmla="*/ 409576 h 555626"/>
              <a:gd name="connsiteX43" fmla="*/ 685800 w 1597025"/>
              <a:gd name="connsiteY43" fmla="*/ 422276 h 555626"/>
              <a:gd name="connsiteX44" fmla="*/ 704850 w 1597025"/>
              <a:gd name="connsiteY44" fmla="*/ 434976 h 555626"/>
              <a:gd name="connsiteX45" fmla="*/ 711200 w 1597025"/>
              <a:gd name="connsiteY45" fmla="*/ 444501 h 555626"/>
              <a:gd name="connsiteX46" fmla="*/ 730250 w 1597025"/>
              <a:gd name="connsiteY46" fmla="*/ 454026 h 555626"/>
              <a:gd name="connsiteX47" fmla="*/ 739775 w 1597025"/>
              <a:gd name="connsiteY47" fmla="*/ 460376 h 555626"/>
              <a:gd name="connsiteX48" fmla="*/ 755650 w 1597025"/>
              <a:gd name="connsiteY48" fmla="*/ 476251 h 555626"/>
              <a:gd name="connsiteX49" fmla="*/ 762000 w 1597025"/>
              <a:gd name="connsiteY49" fmla="*/ 485776 h 555626"/>
              <a:gd name="connsiteX50" fmla="*/ 771525 w 1597025"/>
              <a:gd name="connsiteY50" fmla="*/ 488951 h 555626"/>
              <a:gd name="connsiteX51" fmla="*/ 781050 w 1597025"/>
              <a:gd name="connsiteY51" fmla="*/ 495301 h 555626"/>
              <a:gd name="connsiteX52" fmla="*/ 809625 w 1597025"/>
              <a:gd name="connsiteY52" fmla="*/ 517526 h 555626"/>
              <a:gd name="connsiteX53" fmla="*/ 819150 w 1597025"/>
              <a:gd name="connsiteY53" fmla="*/ 523876 h 555626"/>
              <a:gd name="connsiteX54" fmla="*/ 847725 w 1597025"/>
              <a:gd name="connsiteY54" fmla="*/ 533401 h 555626"/>
              <a:gd name="connsiteX55" fmla="*/ 866775 w 1597025"/>
              <a:gd name="connsiteY55" fmla="*/ 539751 h 555626"/>
              <a:gd name="connsiteX56" fmla="*/ 876300 w 1597025"/>
              <a:gd name="connsiteY56" fmla="*/ 542926 h 555626"/>
              <a:gd name="connsiteX57" fmla="*/ 885825 w 1597025"/>
              <a:gd name="connsiteY57" fmla="*/ 549276 h 555626"/>
              <a:gd name="connsiteX58" fmla="*/ 904875 w 1597025"/>
              <a:gd name="connsiteY58" fmla="*/ 555626 h 555626"/>
              <a:gd name="connsiteX59" fmla="*/ 936625 w 1597025"/>
              <a:gd name="connsiteY59" fmla="*/ 552451 h 555626"/>
              <a:gd name="connsiteX60" fmla="*/ 958850 w 1597025"/>
              <a:gd name="connsiteY60" fmla="*/ 527051 h 555626"/>
              <a:gd name="connsiteX61" fmla="*/ 958850 w 1597025"/>
              <a:gd name="connsiteY61" fmla="*/ 527051 h 555626"/>
              <a:gd name="connsiteX62" fmla="*/ 977900 w 1597025"/>
              <a:gd name="connsiteY62" fmla="*/ 520701 h 555626"/>
              <a:gd name="connsiteX63" fmla="*/ 987425 w 1597025"/>
              <a:gd name="connsiteY63" fmla="*/ 517526 h 555626"/>
              <a:gd name="connsiteX64" fmla="*/ 1000125 w 1597025"/>
              <a:gd name="connsiteY64" fmla="*/ 514351 h 555626"/>
              <a:gd name="connsiteX65" fmla="*/ 1022350 w 1597025"/>
              <a:gd name="connsiteY65" fmla="*/ 517526 h 555626"/>
              <a:gd name="connsiteX66" fmla="*/ 1050925 w 1597025"/>
              <a:gd name="connsiteY66" fmla="*/ 523876 h 555626"/>
              <a:gd name="connsiteX67" fmla="*/ 1111250 w 1597025"/>
              <a:gd name="connsiteY67" fmla="*/ 517526 h 555626"/>
              <a:gd name="connsiteX68" fmla="*/ 1136650 w 1597025"/>
              <a:gd name="connsiteY68" fmla="*/ 511176 h 555626"/>
              <a:gd name="connsiteX69" fmla="*/ 1146175 w 1597025"/>
              <a:gd name="connsiteY69" fmla="*/ 508001 h 555626"/>
              <a:gd name="connsiteX70" fmla="*/ 1155700 w 1597025"/>
              <a:gd name="connsiteY70" fmla="*/ 501651 h 555626"/>
              <a:gd name="connsiteX71" fmla="*/ 1165225 w 1597025"/>
              <a:gd name="connsiteY71" fmla="*/ 482601 h 555626"/>
              <a:gd name="connsiteX72" fmla="*/ 1155700 w 1597025"/>
              <a:gd name="connsiteY72" fmla="*/ 460376 h 555626"/>
              <a:gd name="connsiteX73" fmla="*/ 1146175 w 1597025"/>
              <a:gd name="connsiteY73" fmla="*/ 454026 h 555626"/>
              <a:gd name="connsiteX74" fmla="*/ 1139825 w 1597025"/>
              <a:gd name="connsiteY74" fmla="*/ 428626 h 555626"/>
              <a:gd name="connsiteX75" fmla="*/ 1143000 w 1597025"/>
              <a:gd name="connsiteY75" fmla="*/ 412751 h 555626"/>
              <a:gd name="connsiteX76" fmla="*/ 1162050 w 1597025"/>
              <a:gd name="connsiteY76" fmla="*/ 406401 h 555626"/>
              <a:gd name="connsiteX77" fmla="*/ 1168400 w 1597025"/>
              <a:gd name="connsiteY77" fmla="*/ 387351 h 555626"/>
              <a:gd name="connsiteX78" fmla="*/ 1174750 w 1597025"/>
              <a:gd name="connsiteY78" fmla="*/ 352426 h 555626"/>
              <a:gd name="connsiteX79" fmla="*/ 1177925 w 1597025"/>
              <a:gd name="connsiteY79" fmla="*/ 317501 h 555626"/>
              <a:gd name="connsiteX80" fmla="*/ 1184275 w 1597025"/>
              <a:gd name="connsiteY80" fmla="*/ 298451 h 555626"/>
              <a:gd name="connsiteX81" fmla="*/ 1196975 w 1597025"/>
              <a:gd name="connsiteY81" fmla="*/ 279401 h 555626"/>
              <a:gd name="connsiteX82" fmla="*/ 1187450 w 1597025"/>
              <a:gd name="connsiteY82" fmla="*/ 254001 h 555626"/>
              <a:gd name="connsiteX83" fmla="*/ 1184275 w 1597025"/>
              <a:gd name="connsiteY83" fmla="*/ 244476 h 555626"/>
              <a:gd name="connsiteX84" fmla="*/ 1168400 w 1597025"/>
              <a:gd name="connsiteY84" fmla="*/ 215901 h 555626"/>
              <a:gd name="connsiteX85" fmla="*/ 1165225 w 1597025"/>
              <a:gd name="connsiteY85" fmla="*/ 193676 h 555626"/>
              <a:gd name="connsiteX86" fmla="*/ 1165225 w 1597025"/>
              <a:gd name="connsiteY86" fmla="*/ 165101 h 555626"/>
              <a:gd name="connsiteX87" fmla="*/ 1184275 w 1597025"/>
              <a:gd name="connsiteY87" fmla="*/ 155576 h 555626"/>
              <a:gd name="connsiteX88" fmla="*/ 1196975 w 1597025"/>
              <a:gd name="connsiteY88" fmla="*/ 149226 h 555626"/>
              <a:gd name="connsiteX89" fmla="*/ 1203325 w 1597025"/>
              <a:gd name="connsiteY89" fmla="*/ 139701 h 555626"/>
              <a:gd name="connsiteX90" fmla="*/ 1206500 w 1597025"/>
              <a:gd name="connsiteY90" fmla="*/ 127001 h 555626"/>
              <a:gd name="connsiteX91" fmla="*/ 1209675 w 1597025"/>
              <a:gd name="connsiteY91" fmla="*/ 117476 h 555626"/>
              <a:gd name="connsiteX92" fmla="*/ 1216025 w 1597025"/>
              <a:gd name="connsiteY92" fmla="*/ 95251 h 555626"/>
              <a:gd name="connsiteX93" fmla="*/ 1228725 w 1597025"/>
              <a:gd name="connsiteY93" fmla="*/ 76201 h 555626"/>
              <a:gd name="connsiteX94" fmla="*/ 1238250 w 1597025"/>
              <a:gd name="connsiteY94" fmla="*/ 69851 h 555626"/>
              <a:gd name="connsiteX95" fmla="*/ 1257300 w 1597025"/>
              <a:gd name="connsiteY95" fmla="*/ 63501 h 555626"/>
              <a:gd name="connsiteX96" fmla="*/ 1266825 w 1597025"/>
              <a:gd name="connsiteY96" fmla="*/ 60326 h 555626"/>
              <a:gd name="connsiteX97" fmla="*/ 1276350 w 1597025"/>
              <a:gd name="connsiteY97" fmla="*/ 57151 h 555626"/>
              <a:gd name="connsiteX98" fmla="*/ 1298575 w 1597025"/>
              <a:gd name="connsiteY98" fmla="*/ 50801 h 555626"/>
              <a:gd name="connsiteX99" fmla="*/ 1339850 w 1597025"/>
              <a:gd name="connsiteY99" fmla="*/ 53976 h 555626"/>
              <a:gd name="connsiteX100" fmla="*/ 1358900 w 1597025"/>
              <a:gd name="connsiteY100" fmla="*/ 60326 h 555626"/>
              <a:gd name="connsiteX101" fmla="*/ 1368425 w 1597025"/>
              <a:gd name="connsiteY101" fmla="*/ 63501 h 555626"/>
              <a:gd name="connsiteX102" fmla="*/ 1422400 w 1597025"/>
              <a:gd name="connsiteY102" fmla="*/ 60326 h 555626"/>
              <a:gd name="connsiteX103" fmla="*/ 1431925 w 1597025"/>
              <a:gd name="connsiteY103" fmla="*/ 57151 h 555626"/>
              <a:gd name="connsiteX104" fmla="*/ 1450975 w 1597025"/>
              <a:gd name="connsiteY104" fmla="*/ 44451 h 555626"/>
              <a:gd name="connsiteX105" fmla="*/ 1460500 w 1597025"/>
              <a:gd name="connsiteY105" fmla="*/ 38101 h 555626"/>
              <a:gd name="connsiteX106" fmla="*/ 1470025 w 1597025"/>
              <a:gd name="connsiteY106" fmla="*/ 31751 h 555626"/>
              <a:gd name="connsiteX107" fmla="*/ 1498600 w 1597025"/>
              <a:gd name="connsiteY107" fmla="*/ 22226 h 555626"/>
              <a:gd name="connsiteX108" fmla="*/ 1508125 w 1597025"/>
              <a:gd name="connsiteY108" fmla="*/ 19051 h 555626"/>
              <a:gd name="connsiteX109" fmla="*/ 1533525 w 1597025"/>
              <a:gd name="connsiteY109" fmla="*/ 12701 h 555626"/>
              <a:gd name="connsiteX110" fmla="*/ 1574800 w 1597025"/>
              <a:gd name="connsiteY110" fmla="*/ 3176 h 555626"/>
              <a:gd name="connsiteX111" fmla="*/ 1597025 w 1597025"/>
              <a:gd name="connsiteY111" fmla="*/ 1 h 5556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</a:cxnLst>
            <a:rect l="l" t="t" r="r" b="b"/>
            <a:pathLst>
              <a:path w="1597025" h="555626">
                <a:moveTo>
                  <a:pt x="0" y="6351"/>
                </a:moveTo>
                <a:cubicBezTo>
                  <a:pt x="5292" y="9526"/>
                  <a:pt x="10355" y="13116"/>
                  <a:pt x="15875" y="15876"/>
                </a:cubicBezTo>
                <a:cubicBezTo>
                  <a:pt x="18868" y="17373"/>
                  <a:pt x="22474" y="17426"/>
                  <a:pt x="25400" y="19051"/>
                </a:cubicBezTo>
                <a:lnTo>
                  <a:pt x="53975" y="38101"/>
                </a:lnTo>
                <a:cubicBezTo>
                  <a:pt x="57150" y="40218"/>
                  <a:pt x="59880" y="43244"/>
                  <a:pt x="63500" y="44451"/>
                </a:cubicBezTo>
                <a:cubicBezTo>
                  <a:pt x="69850" y="46568"/>
                  <a:pt x="76981" y="47088"/>
                  <a:pt x="82550" y="50801"/>
                </a:cubicBezTo>
                <a:cubicBezTo>
                  <a:pt x="85725" y="52918"/>
                  <a:pt x="88588" y="55601"/>
                  <a:pt x="92075" y="57151"/>
                </a:cubicBezTo>
                <a:cubicBezTo>
                  <a:pt x="98192" y="59869"/>
                  <a:pt x="105556" y="59788"/>
                  <a:pt x="111125" y="63501"/>
                </a:cubicBezTo>
                <a:cubicBezTo>
                  <a:pt x="117475" y="67734"/>
                  <a:pt x="122935" y="73788"/>
                  <a:pt x="130175" y="76201"/>
                </a:cubicBezTo>
                <a:lnTo>
                  <a:pt x="149225" y="82551"/>
                </a:lnTo>
                <a:cubicBezTo>
                  <a:pt x="152400" y="83609"/>
                  <a:pt x="155503" y="84914"/>
                  <a:pt x="158750" y="85726"/>
                </a:cubicBezTo>
                <a:cubicBezTo>
                  <a:pt x="188249" y="93101"/>
                  <a:pt x="151576" y="84291"/>
                  <a:pt x="190500" y="92076"/>
                </a:cubicBezTo>
                <a:cubicBezTo>
                  <a:pt x="194779" y="92932"/>
                  <a:pt x="198896" y="94534"/>
                  <a:pt x="203200" y="95251"/>
                </a:cubicBezTo>
                <a:cubicBezTo>
                  <a:pt x="222223" y="98421"/>
                  <a:pt x="248509" y="100085"/>
                  <a:pt x="266700" y="101601"/>
                </a:cubicBezTo>
                <a:cubicBezTo>
                  <a:pt x="269875" y="103718"/>
                  <a:pt x="273527" y="105253"/>
                  <a:pt x="276225" y="107951"/>
                </a:cubicBezTo>
                <a:cubicBezTo>
                  <a:pt x="285324" y="117050"/>
                  <a:pt x="280585" y="116672"/>
                  <a:pt x="285750" y="127001"/>
                </a:cubicBezTo>
                <a:cubicBezTo>
                  <a:pt x="287457" y="130414"/>
                  <a:pt x="290550" y="133039"/>
                  <a:pt x="292100" y="136526"/>
                </a:cubicBezTo>
                <a:cubicBezTo>
                  <a:pt x="294818" y="142643"/>
                  <a:pt x="292881" y="151863"/>
                  <a:pt x="298450" y="155576"/>
                </a:cubicBezTo>
                <a:lnTo>
                  <a:pt x="317500" y="168276"/>
                </a:lnTo>
                <a:cubicBezTo>
                  <a:pt x="320675" y="170393"/>
                  <a:pt x="323405" y="173419"/>
                  <a:pt x="327025" y="174626"/>
                </a:cubicBezTo>
                <a:cubicBezTo>
                  <a:pt x="330200" y="175684"/>
                  <a:pt x="333557" y="176304"/>
                  <a:pt x="336550" y="177801"/>
                </a:cubicBezTo>
                <a:cubicBezTo>
                  <a:pt x="339963" y="179508"/>
                  <a:pt x="342588" y="182601"/>
                  <a:pt x="346075" y="184151"/>
                </a:cubicBezTo>
                <a:cubicBezTo>
                  <a:pt x="352192" y="186869"/>
                  <a:pt x="359556" y="186788"/>
                  <a:pt x="365125" y="190501"/>
                </a:cubicBezTo>
                <a:cubicBezTo>
                  <a:pt x="376527" y="198102"/>
                  <a:pt x="377507" y="199962"/>
                  <a:pt x="393700" y="203201"/>
                </a:cubicBezTo>
                <a:cubicBezTo>
                  <a:pt x="431763" y="210814"/>
                  <a:pt x="414804" y="207777"/>
                  <a:pt x="444500" y="212726"/>
                </a:cubicBezTo>
                <a:cubicBezTo>
                  <a:pt x="467923" y="206870"/>
                  <a:pt x="447430" y="208665"/>
                  <a:pt x="466725" y="215901"/>
                </a:cubicBezTo>
                <a:cubicBezTo>
                  <a:pt x="473998" y="218628"/>
                  <a:pt x="504076" y="221761"/>
                  <a:pt x="508000" y="222251"/>
                </a:cubicBezTo>
                <a:lnTo>
                  <a:pt x="527050" y="228601"/>
                </a:lnTo>
                <a:cubicBezTo>
                  <a:pt x="530225" y="229659"/>
                  <a:pt x="533790" y="229920"/>
                  <a:pt x="536575" y="231776"/>
                </a:cubicBezTo>
                <a:cubicBezTo>
                  <a:pt x="563872" y="249974"/>
                  <a:pt x="529335" y="228156"/>
                  <a:pt x="555625" y="241301"/>
                </a:cubicBezTo>
                <a:cubicBezTo>
                  <a:pt x="559038" y="243008"/>
                  <a:pt x="561663" y="246101"/>
                  <a:pt x="565150" y="247651"/>
                </a:cubicBezTo>
                <a:cubicBezTo>
                  <a:pt x="571267" y="250369"/>
                  <a:pt x="577850" y="251884"/>
                  <a:pt x="584200" y="254001"/>
                </a:cubicBezTo>
                <a:cubicBezTo>
                  <a:pt x="587375" y="255059"/>
                  <a:pt x="590940" y="255320"/>
                  <a:pt x="593725" y="257176"/>
                </a:cubicBezTo>
                <a:lnTo>
                  <a:pt x="612775" y="269876"/>
                </a:lnTo>
                <a:cubicBezTo>
                  <a:pt x="614892" y="273051"/>
                  <a:pt x="616145" y="277017"/>
                  <a:pt x="619125" y="279401"/>
                </a:cubicBezTo>
                <a:cubicBezTo>
                  <a:pt x="621738" y="281492"/>
                  <a:pt x="625657" y="281079"/>
                  <a:pt x="628650" y="282576"/>
                </a:cubicBezTo>
                <a:cubicBezTo>
                  <a:pt x="632063" y="284283"/>
                  <a:pt x="635000" y="286809"/>
                  <a:pt x="638175" y="288926"/>
                </a:cubicBezTo>
                <a:cubicBezTo>
                  <a:pt x="640292" y="292101"/>
                  <a:pt x="642082" y="295520"/>
                  <a:pt x="644525" y="298451"/>
                </a:cubicBezTo>
                <a:cubicBezTo>
                  <a:pt x="647400" y="301900"/>
                  <a:pt x="651559" y="304240"/>
                  <a:pt x="654050" y="307976"/>
                </a:cubicBezTo>
                <a:cubicBezTo>
                  <a:pt x="655906" y="310761"/>
                  <a:pt x="655728" y="314508"/>
                  <a:pt x="657225" y="317501"/>
                </a:cubicBezTo>
                <a:cubicBezTo>
                  <a:pt x="658932" y="320914"/>
                  <a:pt x="661458" y="323851"/>
                  <a:pt x="663575" y="327026"/>
                </a:cubicBezTo>
                <a:cubicBezTo>
                  <a:pt x="664633" y="349251"/>
                  <a:pt x="665043" y="371516"/>
                  <a:pt x="666750" y="393701"/>
                </a:cubicBezTo>
                <a:cubicBezTo>
                  <a:pt x="667164" y="399082"/>
                  <a:pt x="668030" y="404523"/>
                  <a:pt x="669925" y="409576"/>
                </a:cubicBezTo>
                <a:cubicBezTo>
                  <a:pt x="675174" y="423573"/>
                  <a:pt x="675249" y="416414"/>
                  <a:pt x="685800" y="422276"/>
                </a:cubicBezTo>
                <a:cubicBezTo>
                  <a:pt x="692471" y="425982"/>
                  <a:pt x="704850" y="434976"/>
                  <a:pt x="704850" y="434976"/>
                </a:cubicBezTo>
                <a:cubicBezTo>
                  <a:pt x="706967" y="438151"/>
                  <a:pt x="708502" y="441803"/>
                  <a:pt x="711200" y="444501"/>
                </a:cubicBezTo>
                <a:cubicBezTo>
                  <a:pt x="720299" y="453600"/>
                  <a:pt x="719921" y="448861"/>
                  <a:pt x="730250" y="454026"/>
                </a:cubicBezTo>
                <a:cubicBezTo>
                  <a:pt x="733663" y="455733"/>
                  <a:pt x="736600" y="458259"/>
                  <a:pt x="739775" y="460376"/>
                </a:cubicBezTo>
                <a:cubicBezTo>
                  <a:pt x="756708" y="485776"/>
                  <a:pt x="734483" y="455084"/>
                  <a:pt x="755650" y="476251"/>
                </a:cubicBezTo>
                <a:cubicBezTo>
                  <a:pt x="758348" y="478949"/>
                  <a:pt x="759020" y="483392"/>
                  <a:pt x="762000" y="485776"/>
                </a:cubicBezTo>
                <a:cubicBezTo>
                  <a:pt x="764613" y="487867"/>
                  <a:pt x="768532" y="487454"/>
                  <a:pt x="771525" y="488951"/>
                </a:cubicBezTo>
                <a:cubicBezTo>
                  <a:pt x="774938" y="490658"/>
                  <a:pt x="778119" y="492858"/>
                  <a:pt x="781050" y="495301"/>
                </a:cubicBezTo>
                <a:cubicBezTo>
                  <a:pt x="810893" y="520170"/>
                  <a:pt x="761477" y="485428"/>
                  <a:pt x="809625" y="517526"/>
                </a:cubicBezTo>
                <a:cubicBezTo>
                  <a:pt x="812800" y="519643"/>
                  <a:pt x="815530" y="522669"/>
                  <a:pt x="819150" y="523876"/>
                </a:cubicBezTo>
                <a:lnTo>
                  <a:pt x="847725" y="533401"/>
                </a:lnTo>
                <a:lnTo>
                  <a:pt x="866775" y="539751"/>
                </a:lnTo>
                <a:cubicBezTo>
                  <a:pt x="869950" y="540809"/>
                  <a:pt x="873515" y="541070"/>
                  <a:pt x="876300" y="542926"/>
                </a:cubicBezTo>
                <a:cubicBezTo>
                  <a:pt x="879475" y="545043"/>
                  <a:pt x="882338" y="547726"/>
                  <a:pt x="885825" y="549276"/>
                </a:cubicBezTo>
                <a:cubicBezTo>
                  <a:pt x="891942" y="551994"/>
                  <a:pt x="904875" y="555626"/>
                  <a:pt x="904875" y="555626"/>
                </a:cubicBezTo>
                <a:cubicBezTo>
                  <a:pt x="915458" y="554568"/>
                  <a:pt x="926261" y="554843"/>
                  <a:pt x="936625" y="552451"/>
                </a:cubicBezTo>
                <a:cubicBezTo>
                  <a:pt x="947048" y="550046"/>
                  <a:pt x="954937" y="532920"/>
                  <a:pt x="958850" y="527051"/>
                </a:cubicBezTo>
                <a:lnTo>
                  <a:pt x="958850" y="527051"/>
                </a:lnTo>
                <a:lnTo>
                  <a:pt x="977900" y="520701"/>
                </a:lnTo>
                <a:cubicBezTo>
                  <a:pt x="981075" y="519643"/>
                  <a:pt x="984178" y="518338"/>
                  <a:pt x="987425" y="517526"/>
                </a:cubicBezTo>
                <a:lnTo>
                  <a:pt x="1000125" y="514351"/>
                </a:lnTo>
                <a:cubicBezTo>
                  <a:pt x="1007533" y="515409"/>
                  <a:pt x="1014968" y="516296"/>
                  <a:pt x="1022350" y="517526"/>
                </a:cubicBezTo>
                <a:cubicBezTo>
                  <a:pt x="1034442" y="519541"/>
                  <a:pt x="1039508" y="521022"/>
                  <a:pt x="1050925" y="523876"/>
                </a:cubicBezTo>
                <a:cubicBezTo>
                  <a:pt x="1074349" y="522074"/>
                  <a:pt x="1089911" y="522099"/>
                  <a:pt x="1111250" y="517526"/>
                </a:cubicBezTo>
                <a:cubicBezTo>
                  <a:pt x="1119784" y="515697"/>
                  <a:pt x="1128371" y="513936"/>
                  <a:pt x="1136650" y="511176"/>
                </a:cubicBezTo>
                <a:cubicBezTo>
                  <a:pt x="1139825" y="510118"/>
                  <a:pt x="1143182" y="509498"/>
                  <a:pt x="1146175" y="508001"/>
                </a:cubicBezTo>
                <a:cubicBezTo>
                  <a:pt x="1149588" y="506294"/>
                  <a:pt x="1152525" y="503768"/>
                  <a:pt x="1155700" y="501651"/>
                </a:cubicBezTo>
                <a:cubicBezTo>
                  <a:pt x="1158911" y="496835"/>
                  <a:pt x="1165225" y="489174"/>
                  <a:pt x="1165225" y="482601"/>
                </a:cubicBezTo>
                <a:cubicBezTo>
                  <a:pt x="1165225" y="475314"/>
                  <a:pt x="1160885" y="465561"/>
                  <a:pt x="1155700" y="460376"/>
                </a:cubicBezTo>
                <a:cubicBezTo>
                  <a:pt x="1153002" y="457678"/>
                  <a:pt x="1149350" y="456143"/>
                  <a:pt x="1146175" y="454026"/>
                </a:cubicBezTo>
                <a:cubicBezTo>
                  <a:pt x="1143670" y="446510"/>
                  <a:pt x="1139825" y="436289"/>
                  <a:pt x="1139825" y="428626"/>
                </a:cubicBezTo>
                <a:cubicBezTo>
                  <a:pt x="1139825" y="423230"/>
                  <a:pt x="1139184" y="416567"/>
                  <a:pt x="1143000" y="412751"/>
                </a:cubicBezTo>
                <a:cubicBezTo>
                  <a:pt x="1147733" y="408018"/>
                  <a:pt x="1162050" y="406401"/>
                  <a:pt x="1162050" y="406401"/>
                </a:cubicBezTo>
                <a:cubicBezTo>
                  <a:pt x="1164167" y="400051"/>
                  <a:pt x="1167087" y="393915"/>
                  <a:pt x="1168400" y="387351"/>
                </a:cubicBezTo>
                <a:cubicBezTo>
                  <a:pt x="1170405" y="377325"/>
                  <a:pt x="1173589" y="362291"/>
                  <a:pt x="1174750" y="352426"/>
                </a:cubicBezTo>
                <a:cubicBezTo>
                  <a:pt x="1176116" y="340816"/>
                  <a:pt x="1175894" y="329013"/>
                  <a:pt x="1177925" y="317501"/>
                </a:cubicBezTo>
                <a:cubicBezTo>
                  <a:pt x="1179088" y="310909"/>
                  <a:pt x="1180562" y="304020"/>
                  <a:pt x="1184275" y="298451"/>
                </a:cubicBezTo>
                <a:lnTo>
                  <a:pt x="1196975" y="279401"/>
                </a:lnTo>
                <a:cubicBezTo>
                  <a:pt x="1190849" y="248773"/>
                  <a:pt x="1198351" y="275802"/>
                  <a:pt x="1187450" y="254001"/>
                </a:cubicBezTo>
                <a:cubicBezTo>
                  <a:pt x="1185953" y="251008"/>
                  <a:pt x="1185900" y="247402"/>
                  <a:pt x="1184275" y="244476"/>
                </a:cubicBezTo>
                <a:cubicBezTo>
                  <a:pt x="1166079" y="211724"/>
                  <a:pt x="1175584" y="237454"/>
                  <a:pt x="1168400" y="215901"/>
                </a:cubicBezTo>
                <a:cubicBezTo>
                  <a:pt x="1167342" y="208493"/>
                  <a:pt x="1166455" y="201058"/>
                  <a:pt x="1165225" y="193676"/>
                </a:cubicBezTo>
                <a:cubicBezTo>
                  <a:pt x="1163580" y="183806"/>
                  <a:pt x="1158812" y="174721"/>
                  <a:pt x="1165225" y="165101"/>
                </a:cubicBezTo>
                <a:cubicBezTo>
                  <a:pt x="1169293" y="158999"/>
                  <a:pt x="1178359" y="158112"/>
                  <a:pt x="1184275" y="155576"/>
                </a:cubicBezTo>
                <a:cubicBezTo>
                  <a:pt x="1188625" y="153712"/>
                  <a:pt x="1192742" y="151343"/>
                  <a:pt x="1196975" y="149226"/>
                </a:cubicBezTo>
                <a:cubicBezTo>
                  <a:pt x="1199092" y="146051"/>
                  <a:pt x="1201822" y="143208"/>
                  <a:pt x="1203325" y="139701"/>
                </a:cubicBezTo>
                <a:cubicBezTo>
                  <a:pt x="1205044" y="135690"/>
                  <a:pt x="1205301" y="131197"/>
                  <a:pt x="1206500" y="127001"/>
                </a:cubicBezTo>
                <a:cubicBezTo>
                  <a:pt x="1207419" y="123783"/>
                  <a:pt x="1208756" y="120694"/>
                  <a:pt x="1209675" y="117476"/>
                </a:cubicBezTo>
                <a:cubicBezTo>
                  <a:pt x="1210642" y="114091"/>
                  <a:pt x="1213786" y="99281"/>
                  <a:pt x="1216025" y="95251"/>
                </a:cubicBezTo>
                <a:cubicBezTo>
                  <a:pt x="1219731" y="88580"/>
                  <a:pt x="1222375" y="80434"/>
                  <a:pt x="1228725" y="76201"/>
                </a:cubicBezTo>
                <a:cubicBezTo>
                  <a:pt x="1231900" y="74084"/>
                  <a:pt x="1234763" y="71401"/>
                  <a:pt x="1238250" y="69851"/>
                </a:cubicBezTo>
                <a:cubicBezTo>
                  <a:pt x="1244367" y="67133"/>
                  <a:pt x="1250950" y="65618"/>
                  <a:pt x="1257300" y="63501"/>
                </a:cubicBezTo>
                <a:lnTo>
                  <a:pt x="1266825" y="60326"/>
                </a:lnTo>
                <a:cubicBezTo>
                  <a:pt x="1270000" y="59268"/>
                  <a:pt x="1273103" y="57963"/>
                  <a:pt x="1276350" y="57151"/>
                </a:cubicBezTo>
                <a:cubicBezTo>
                  <a:pt x="1292297" y="53164"/>
                  <a:pt x="1284910" y="55356"/>
                  <a:pt x="1298575" y="50801"/>
                </a:cubicBezTo>
                <a:cubicBezTo>
                  <a:pt x="1312333" y="51859"/>
                  <a:pt x="1326220" y="51824"/>
                  <a:pt x="1339850" y="53976"/>
                </a:cubicBezTo>
                <a:cubicBezTo>
                  <a:pt x="1346462" y="55020"/>
                  <a:pt x="1352550" y="58209"/>
                  <a:pt x="1358900" y="60326"/>
                </a:cubicBezTo>
                <a:lnTo>
                  <a:pt x="1368425" y="63501"/>
                </a:lnTo>
                <a:cubicBezTo>
                  <a:pt x="1386417" y="62443"/>
                  <a:pt x="1404467" y="62119"/>
                  <a:pt x="1422400" y="60326"/>
                </a:cubicBezTo>
                <a:cubicBezTo>
                  <a:pt x="1425730" y="59993"/>
                  <a:pt x="1428999" y="58776"/>
                  <a:pt x="1431925" y="57151"/>
                </a:cubicBezTo>
                <a:cubicBezTo>
                  <a:pt x="1438596" y="53445"/>
                  <a:pt x="1444625" y="48684"/>
                  <a:pt x="1450975" y="44451"/>
                </a:cubicBezTo>
                <a:lnTo>
                  <a:pt x="1460500" y="38101"/>
                </a:lnTo>
                <a:cubicBezTo>
                  <a:pt x="1463675" y="35984"/>
                  <a:pt x="1466405" y="32958"/>
                  <a:pt x="1470025" y="31751"/>
                </a:cubicBezTo>
                <a:lnTo>
                  <a:pt x="1498600" y="22226"/>
                </a:lnTo>
                <a:cubicBezTo>
                  <a:pt x="1501775" y="21168"/>
                  <a:pt x="1504878" y="19863"/>
                  <a:pt x="1508125" y="19051"/>
                </a:cubicBezTo>
                <a:cubicBezTo>
                  <a:pt x="1516592" y="16934"/>
                  <a:pt x="1525246" y="15461"/>
                  <a:pt x="1533525" y="12701"/>
                </a:cubicBezTo>
                <a:cubicBezTo>
                  <a:pt x="1551116" y="6837"/>
                  <a:pt x="1546775" y="7847"/>
                  <a:pt x="1574800" y="3176"/>
                </a:cubicBezTo>
                <a:cubicBezTo>
                  <a:pt x="1594894" y="-173"/>
                  <a:pt x="1587412" y="1"/>
                  <a:pt x="1597025" y="1"/>
                </a:cubicBezTo>
              </a:path>
            </a:pathLst>
          </a:custGeom>
          <a:ln w="6350" cmpd="sng">
            <a:solidFill>
              <a:srgbClr val="FFFFFF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Freeform 35"/>
          <p:cNvSpPr/>
          <p:nvPr/>
        </p:nvSpPr>
        <p:spPr>
          <a:xfrm>
            <a:off x="3321352" y="7486649"/>
            <a:ext cx="1597025" cy="555626"/>
          </a:xfrm>
          <a:custGeom>
            <a:avLst/>
            <a:gdLst>
              <a:gd name="connsiteX0" fmla="*/ 0 w 1597025"/>
              <a:gd name="connsiteY0" fmla="*/ 6351 h 555626"/>
              <a:gd name="connsiteX1" fmla="*/ 15875 w 1597025"/>
              <a:gd name="connsiteY1" fmla="*/ 15876 h 555626"/>
              <a:gd name="connsiteX2" fmla="*/ 25400 w 1597025"/>
              <a:gd name="connsiteY2" fmla="*/ 19051 h 555626"/>
              <a:gd name="connsiteX3" fmla="*/ 53975 w 1597025"/>
              <a:gd name="connsiteY3" fmla="*/ 38101 h 555626"/>
              <a:gd name="connsiteX4" fmla="*/ 63500 w 1597025"/>
              <a:gd name="connsiteY4" fmla="*/ 44451 h 555626"/>
              <a:gd name="connsiteX5" fmla="*/ 82550 w 1597025"/>
              <a:gd name="connsiteY5" fmla="*/ 50801 h 555626"/>
              <a:gd name="connsiteX6" fmla="*/ 92075 w 1597025"/>
              <a:gd name="connsiteY6" fmla="*/ 57151 h 555626"/>
              <a:gd name="connsiteX7" fmla="*/ 111125 w 1597025"/>
              <a:gd name="connsiteY7" fmla="*/ 63501 h 555626"/>
              <a:gd name="connsiteX8" fmla="*/ 130175 w 1597025"/>
              <a:gd name="connsiteY8" fmla="*/ 76201 h 555626"/>
              <a:gd name="connsiteX9" fmla="*/ 149225 w 1597025"/>
              <a:gd name="connsiteY9" fmla="*/ 82551 h 555626"/>
              <a:gd name="connsiteX10" fmla="*/ 158750 w 1597025"/>
              <a:gd name="connsiteY10" fmla="*/ 85726 h 555626"/>
              <a:gd name="connsiteX11" fmla="*/ 190500 w 1597025"/>
              <a:gd name="connsiteY11" fmla="*/ 92076 h 555626"/>
              <a:gd name="connsiteX12" fmla="*/ 203200 w 1597025"/>
              <a:gd name="connsiteY12" fmla="*/ 95251 h 555626"/>
              <a:gd name="connsiteX13" fmla="*/ 266700 w 1597025"/>
              <a:gd name="connsiteY13" fmla="*/ 101601 h 555626"/>
              <a:gd name="connsiteX14" fmla="*/ 276225 w 1597025"/>
              <a:gd name="connsiteY14" fmla="*/ 107951 h 555626"/>
              <a:gd name="connsiteX15" fmla="*/ 285750 w 1597025"/>
              <a:gd name="connsiteY15" fmla="*/ 127001 h 555626"/>
              <a:gd name="connsiteX16" fmla="*/ 292100 w 1597025"/>
              <a:gd name="connsiteY16" fmla="*/ 136526 h 555626"/>
              <a:gd name="connsiteX17" fmla="*/ 298450 w 1597025"/>
              <a:gd name="connsiteY17" fmla="*/ 155576 h 555626"/>
              <a:gd name="connsiteX18" fmla="*/ 317500 w 1597025"/>
              <a:gd name="connsiteY18" fmla="*/ 168276 h 555626"/>
              <a:gd name="connsiteX19" fmla="*/ 327025 w 1597025"/>
              <a:gd name="connsiteY19" fmla="*/ 174626 h 555626"/>
              <a:gd name="connsiteX20" fmla="*/ 336550 w 1597025"/>
              <a:gd name="connsiteY20" fmla="*/ 177801 h 555626"/>
              <a:gd name="connsiteX21" fmla="*/ 346075 w 1597025"/>
              <a:gd name="connsiteY21" fmla="*/ 184151 h 555626"/>
              <a:gd name="connsiteX22" fmla="*/ 365125 w 1597025"/>
              <a:gd name="connsiteY22" fmla="*/ 190501 h 555626"/>
              <a:gd name="connsiteX23" fmla="*/ 393700 w 1597025"/>
              <a:gd name="connsiteY23" fmla="*/ 203201 h 555626"/>
              <a:gd name="connsiteX24" fmla="*/ 444500 w 1597025"/>
              <a:gd name="connsiteY24" fmla="*/ 212726 h 555626"/>
              <a:gd name="connsiteX25" fmla="*/ 466725 w 1597025"/>
              <a:gd name="connsiteY25" fmla="*/ 215901 h 555626"/>
              <a:gd name="connsiteX26" fmla="*/ 508000 w 1597025"/>
              <a:gd name="connsiteY26" fmla="*/ 222251 h 555626"/>
              <a:gd name="connsiteX27" fmla="*/ 527050 w 1597025"/>
              <a:gd name="connsiteY27" fmla="*/ 228601 h 555626"/>
              <a:gd name="connsiteX28" fmla="*/ 536575 w 1597025"/>
              <a:gd name="connsiteY28" fmla="*/ 231776 h 555626"/>
              <a:gd name="connsiteX29" fmla="*/ 555625 w 1597025"/>
              <a:gd name="connsiteY29" fmla="*/ 241301 h 555626"/>
              <a:gd name="connsiteX30" fmla="*/ 565150 w 1597025"/>
              <a:gd name="connsiteY30" fmla="*/ 247651 h 555626"/>
              <a:gd name="connsiteX31" fmla="*/ 584200 w 1597025"/>
              <a:gd name="connsiteY31" fmla="*/ 254001 h 555626"/>
              <a:gd name="connsiteX32" fmla="*/ 593725 w 1597025"/>
              <a:gd name="connsiteY32" fmla="*/ 257176 h 555626"/>
              <a:gd name="connsiteX33" fmla="*/ 612775 w 1597025"/>
              <a:gd name="connsiteY33" fmla="*/ 269876 h 555626"/>
              <a:gd name="connsiteX34" fmla="*/ 619125 w 1597025"/>
              <a:gd name="connsiteY34" fmla="*/ 279401 h 555626"/>
              <a:gd name="connsiteX35" fmla="*/ 628650 w 1597025"/>
              <a:gd name="connsiteY35" fmla="*/ 282576 h 555626"/>
              <a:gd name="connsiteX36" fmla="*/ 638175 w 1597025"/>
              <a:gd name="connsiteY36" fmla="*/ 288926 h 555626"/>
              <a:gd name="connsiteX37" fmla="*/ 644525 w 1597025"/>
              <a:gd name="connsiteY37" fmla="*/ 298451 h 555626"/>
              <a:gd name="connsiteX38" fmla="*/ 654050 w 1597025"/>
              <a:gd name="connsiteY38" fmla="*/ 307976 h 555626"/>
              <a:gd name="connsiteX39" fmla="*/ 657225 w 1597025"/>
              <a:gd name="connsiteY39" fmla="*/ 317501 h 555626"/>
              <a:gd name="connsiteX40" fmla="*/ 663575 w 1597025"/>
              <a:gd name="connsiteY40" fmla="*/ 327026 h 555626"/>
              <a:gd name="connsiteX41" fmla="*/ 666750 w 1597025"/>
              <a:gd name="connsiteY41" fmla="*/ 393701 h 555626"/>
              <a:gd name="connsiteX42" fmla="*/ 669925 w 1597025"/>
              <a:gd name="connsiteY42" fmla="*/ 409576 h 555626"/>
              <a:gd name="connsiteX43" fmla="*/ 685800 w 1597025"/>
              <a:gd name="connsiteY43" fmla="*/ 422276 h 555626"/>
              <a:gd name="connsiteX44" fmla="*/ 704850 w 1597025"/>
              <a:gd name="connsiteY44" fmla="*/ 434976 h 555626"/>
              <a:gd name="connsiteX45" fmla="*/ 711200 w 1597025"/>
              <a:gd name="connsiteY45" fmla="*/ 444501 h 555626"/>
              <a:gd name="connsiteX46" fmla="*/ 730250 w 1597025"/>
              <a:gd name="connsiteY46" fmla="*/ 454026 h 555626"/>
              <a:gd name="connsiteX47" fmla="*/ 739775 w 1597025"/>
              <a:gd name="connsiteY47" fmla="*/ 460376 h 555626"/>
              <a:gd name="connsiteX48" fmla="*/ 755650 w 1597025"/>
              <a:gd name="connsiteY48" fmla="*/ 476251 h 555626"/>
              <a:gd name="connsiteX49" fmla="*/ 762000 w 1597025"/>
              <a:gd name="connsiteY49" fmla="*/ 485776 h 555626"/>
              <a:gd name="connsiteX50" fmla="*/ 771525 w 1597025"/>
              <a:gd name="connsiteY50" fmla="*/ 488951 h 555626"/>
              <a:gd name="connsiteX51" fmla="*/ 781050 w 1597025"/>
              <a:gd name="connsiteY51" fmla="*/ 495301 h 555626"/>
              <a:gd name="connsiteX52" fmla="*/ 809625 w 1597025"/>
              <a:gd name="connsiteY52" fmla="*/ 517526 h 555626"/>
              <a:gd name="connsiteX53" fmla="*/ 819150 w 1597025"/>
              <a:gd name="connsiteY53" fmla="*/ 523876 h 555626"/>
              <a:gd name="connsiteX54" fmla="*/ 847725 w 1597025"/>
              <a:gd name="connsiteY54" fmla="*/ 533401 h 555626"/>
              <a:gd name="connsiteX55" fmla="*/ 866775 w 1597025"/>
              <a:gd name="connsiteY55" fmla="*/ 539751 h 555626"/>
              <a:gd name="connsiteX56" fmla="*/ 876300 w 1597025"/>
              <a:gd name="connsiteY56" fmla="*/ 542926 h 555626"/>
              <a:gd name="connsiteX57" fmla="*/ 885825 w 1597025"/>
              <a:gd name="connsiteY57" fmla="*/ 549276 h 555626"/>
              <a:gd name="connsiteX58" fmla="*/ 904875 w 1597025"/>
              <a:gd name="connsiteY58" fmla="*/ 555626 h 555626"/>
              <a:gd name="connsiteX59" fmla="*/ 936625 w 1597025"/>
              <a:gd name="connsiteY59" fmla="*/ 552451 h 555626"/>
              <a:gd name="connsiteX60" fmla="*/ 958850 w 1597025"/>
              <a:gd name="connsiteY60" fmla="*/ 527051 h 555626"/>
              <a:gd name="connsiteX61" fmla="*/ 958850 w 1597025"/>
              <a:gd name="connsiteY61" fmla="*/ 527051 h 555626"/>
              <a:gd name="connsiteX62" fmla="*/ 977900 w 1597025"/>
              <a:gd name="connsiteY62" fmla="*/ 520701 h 555626"/>
              <a:gd name="connsiteX63" fmla="*/ 987425 w 1597025"/>
              <a:gd name="connsiteY63" fmla="*/ 517526 h 555626"/>
              <a:gd name="connsiteX64" fmla="*/ 1000125 w 1597025"/>
              <a:gd name="connsiteY64" fmla="*/ 514351 h 555626"/>
              <a:gd name="connsiteX65" fmla="*/ 1022350 w 1597025"/>
              <a:gd name="connsiteY65" fmla="*/ 517526 h 555626"/>
              <a:gd name="connsiteX66" fmla="*/ 1050925 w 1597025"/>
              <a:gd name="connsiteY66" fmla="*/ 523876 h 555626"/>
              <a:gd name="connsiteX67" fmla="*/ 1111250 w 1597025"/>
              <a:gd name="connsiteY67" fmla="*/ 517526 h 555626"/>
              <a:gd name="connsiteX68" fmla="*/ 1136650 w 1597025"/>
              <a:gd name="connsiteY68" fmla="*/ 511176 h 555626"/>
              <a:gd name="connsiteX69" fmla="*/ 1146175 w 1597025"/>
              <a:gd name="connsiteY69" fmla="*/ 508001 h 555626"/>
              <a:gd name="connsiteX70" fmla="*/ 1155700 w 1597025"/>
              <a:gd name="connsiteY70" fmla="*/ 501651 h 555626"/>
              <a:gd name="connsiteX71" fmla="*/ 1165225 w 1597025"/>
              <a:gd name="connsiteY71" fmla="*/ 482601 h 555626"/>
              <a:gd name="connsiteX72" fmla="*/ 1155700 w 1597025"/>
              <a:gd name="connsiteY72" fmla="*/ 460376 h 555626"/>
              <a:gd name="connsiteX73" fmla="*/ 1146175 w 1597025"/>
              <a:gd name="connsiteY73" fmla="*/ 454026 h 555626"/>
              <a:gd name="connsiteX74" fmla="*/ 1139825 w 1597025"/>
              <a:gd name="connsiteY74" fmla="*/ 428626 h 555626"/>
              <a:gd name="connsiteX75" fmla="*/ 1143000 w 1597025"/>
              <a:gd name="connsiteY75" fmla="*/ 412751 h 555626"/>
              <a:gd name="connsiteX76" fmla="*/ 1162050 w 1597025"/>
              <a:gd name="connsiteY76" fmla="*/ 406401 h 555626"/>
              <a:gd name="connsiteX77" fmla="*/ 1168400 w 1597025"/>
              <a:gd name="connsiteY77" fmla="*/ 387351 h 555626"/>
              <a:gd name="connsiteX78" fmla="*/ 1174750 w 1597025"/>
              <a:gd name="connsiteY78" fmla="*/ 352426 h 555626"/>
              <a:gd name="connsiteX79" fmla="*/ 1177925 w 1597025"/>
              <a:gd name="connsiteY79" fmla="*/ 317501 h 555626"/>
              <a:gd name="connsiteX80" fmla="*/ 1184275 w 1597025"/>
              <a:gd name="connsiteY80" fmla="*/ 298451 h 555626"/>
              <a:gd name="connsiteX81" fmla="*/ 1196975 w 1597025"/>
              <a:gd name="connsiteY81" fmla="*/ 279401 h 555626"/>
              <a:gd name="connsiteX82" fmla="*/ 1187450 w 1597025"/>
              <a:gd name="connsiteY82" fmla="*/ 254001 h 555626"/>
              <a:gd name="connsiteX83" fmla="*/ 1184275 w 1597025"/>
              <a:gd name="connsiteY83" fmla="*/ 244476 h 555626"/>
              <a:gd name="connsiteX84" fmla="*/ 1168400 w 1597025"/>
              <a:gd name="connsiteY84" fmla="*/ 215901 h 555626"/>
              <a:gd name="connsiteX85" fmla="*/ 1165225 w 1597025"/>
              <a:gd name="connsiteY85" fmla="*/ 193676 h 555626"/>
              <a:gd name="connsiteX86" fmla="*/ 1165225 w 1597025"/>
              <a:gd name="connsiteY86" fmla="*/ 165101 h 555626"/>
              <a:gd name="connsiteX87" fmla="*/ 1184275 w 1597025"/>
              <a:gd name="connsiteY87" fmla="*/ 155576 h 555626"/>
              <a:gd name="connsiteX88" fmla="*/ 1196975 w 1597025"/>
              <a:gd name="connsiteY88" fmla="*/ 149226 h 555626"/>
              <a:gd name="connsiteX89" fmla="*/ 1203325 w 1597025"/>
              <a:gd name="connsiteY89" fmla="*/ 139701 h 555626"/>
              <a:gd name="connsiteX90" fmla="*/ 1206500 w 1597025"/>
              <a:gd name="connsiteY90" fmla="*/ 127001 h 555626"/>
              <a:gd name="connsiteX91" fmla="*/ 1209675 w 1597025"/>
              <a:gd name="connsiteY91" fmla="*/ 117476 h 555626"/>
              <a:gd name="connsiteX92" fmla="*/ 1216025 w 1597025"/>
              <a:gd name="connsiteY92" fmla="*/ 95251 h 555626"/>
              <a:gd name="connsiteX93" fmla="*/ 1228725 w 1597025"/>
              <a:gd name="connsiteY93" fmla="*/ 76201 h 555626"/>
              <a:gd name="connsiteX94" fmla="*/ 1238250 w 1597025"/>
              <a:gd name="connsiteY94" fmla="*/ 69851 h 555626"/>
              <a:gd name="connsiteX95" fmla="*/ 1257300 w 1597025"/>
              <a:gd name="connsiteY95" fmla="*/ 63501 h 555626"/>
              <a:gd name="connsiteX96" fmla="*/ 1266825 w 1597025"/>
              <a:gd name="connsiteY96" fmla="*/ 60326 h 555626"/>
              <a:gd name="connsiteX97" fmla="*/ 1276350 w 1597025"/>
              <a:gd name="connsiteY97" fmla="*/ 57151 h 555626"/>
              <a:gd name="connsiteX98" fmla="*/ 1298575 w 1597025"/>
              <a:gd name="connsiteY98" fmla="*/ 50801 h 555626"/>
              <a:gd name="connsiteX99" fmla="*/ 1339850 w 1597025"/>
              <a:gd name="connsiteY99" fmla="*/ 53976 h 555626"/>
              <a:gd name="connsiteX100" fmla="*/ 1358900 w 1597025"/>
              <a:gd name="connsiteY100" fmla="*/ 60326 h 555626"/>
              <a:gd name="connsiteX101" fmla="*/ 1368425 w 1597025"/>
              <a:gd name="connsiteY101" fmla="*/ 63501 h 555626"/>
              <a:gd name="connsiteX102" fmla="*/ 1422400 w 1597025"/>
              <a:gd name="connsiteY102" fmla="*/ 60326 h 555626"/>
              <a:gd name="connsiteX103" fmla="*/ 1431925 w 1597025"/>
              <a:gd name="connsiteY103" fmla="*/ 57151 h 555626"/>
              <a:gd name="connsiteX104" fmla="*/ 1450975 w 1597025"/>
              <a:gd name="connsiteY104" fmla="*/ 44451 h 555626"/>
              <a:gd name="connsiteX105" fmla="*/ 1460500 w 1597025"/>
              <a:gd name="connsiteY105" fmla="*/ 38101 h 555626"/>
              <a:gd name="connsiteX106" fmla="*/ 1470025 w 1597025"/>
              <a:gd name="connsiteY106" fmla="*/ 31751 h 555626"/>
              <a:gd name="connsiteX107" fmla="*/ 1498600 w 1597025"/>
              <a:gd name="connsiteY107" fmla="*/ 22226 h 555626"/>
              <a:gd name="connsiteX108" fmla="*/ 1508125 w 1597025"/>
              <a:gd name="connsiteY108" fmla="*/ 19051 h 555626"/>
              <a:gd name="connsiteX109" fmla="*/ 1533525 w 1597025"/>
              <a:gd name="connsiteY109" fmla="*/ 12701 h 555626"/>
              <a:gd name="connsiteX110" fmla="*/ 1574800 w 1597025"/>
              <a:gd name="connsiteY110" fmla="*/ 3176 h 555626"/>
              <a:gd name="connsiteX111" fmla="*/ 1597025 w 1597025"/>
              <a:gd name="connsiteY111" fmla="*/ 1 h 55562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</a:cxnLst>
            <a:rect l="l" t="t" r="r" b="b"/>
            <a:pathLst>
              <a:path w="1597025" h="555626">
                <a:moveTo>
                  <a:pt x="0" y="6351"/>
                </a:moveTo>
                <a:cubicBezTo>
                  <a:pt x="5292" y="9526"/>
                  <a:pt x="10355" y="13116"/>
                  <a:pt x="15875" y="15876"/>
                </a:cubicBezTo>
                <a:cubicBezTo>
                  <a:pt x="18868" y="17373"/>
                  <a:pt x="22474" y="17426"/>
                  <a:pt x="25400" y="19051"/>
                </a:cubicBezTo>
                <a:lnTo>
                  <a:pt x="53975" y="38101"/>
                </a:lnTo>
                <a:cubicBezTo>
                  <a:pt x="57150" y="40218"/>
                  <a:pt x="59880" y="43244"/>
                  <a:pt x="63500" y="44451"/>
                </a:cubicBezTo>
                <a:cubicBezTo>
                  <a:pt x="69850" y="46568"/>
                  <a:pt x="76981" y="47088"/>
                  <a:pt x="82550" y="50801"/>
                </a:cubicBezTo>
                <a:cubicBezTo>
                  <a:pt x="85725" y="52918"/>
                  <a:pt x="88588" y="55601"/>
                  <a:pt x="92075" y="57151"/>
                </a:cubicBezTo>
                <a:cubicBezTo>
                  <a:pt x="98192" y="59869"/>
                  <a:pt x="105556" y="59788"/>
                  <a:pt x="111125" y="63501"/>
                </a:cubicBezTo>
                <a:cubicBezTo>
                  <a:pt x="117475" y="67734"/>
                  <a:pt x="122935" y="73788"/>
                  <a:pt x="130175" y="76201"/>
                </a:cubicBezTo>
                <a:lnTo>
                  <a:pt x="149225" y="82551"/>
                </a:lnTo>
                <a:cubicBezTo>
                  <a:pt x="152400" y="83609"/>
                  <a:pt x="155503" y="84914"/>
                  <a:pt x="158750" y="85726"/>
                </a:cubicBezTo>
                <a:cubicBezTo>
                  <a:pt x="188249" y="93101"/>
                  <a:pt x="151576" y="84291"/>
                  <a:pt x="190500" y="92076"/>
                </a:cubicBezTo>
                <a:cubicBezTo>
                  <a:pt x="194779" y="92932"/>
                  <a:pt x="198896" y="94534"/>
                  <a:pt x="203200" y="95251"/>
                </a:cubicBezTo>
                <a:cubicBezTo>
                  <a:pt x="222223" y="98421"/>
                  <a:pt x="248509" y="100085"/>
                  <a:pt x="266700" y="101601"/>
                </a:cubicBezTo>
                <a:cubicBezTo>
                  <a:pt x="269875" y="103718"/>
                  <a:pt x="273527" y="105253"/>
                  <a:pt x="276225" y="107951"/>
                </a:cubicBezTo>
                <a:cubicBezTo>
                  <a:pt x="285324" y="117050"/>
                  <a:pt x="280585" y="116672"/>
                  <a:pt x="285750" y="127001"/>
                </a:cubicBezTo>
                <a:cubicBezTo>
                  <a:pt x="287457" y="130414"/>
                  <a:pt x="290550" y="133039"/>
                  <a:pt x="292100" y="136526"/>
                </a:cubicBezTo>
                <a:cubicBezTo>
                  <a:pt x="294818" y="142643"/>
                  <a:pt x="292881" y="151863"/>
                  <a:pt x="298450" y="155576"/>
                </a:cubicBezTo>
                <a:lnTo>
                  <a:pt x="317500" y="168276"/>
                </a:lnTo>
                <a:cubicBezTo>
                  <a:pt x="320675" y="170393"/>
                  <a:pt x="323405" y="173419"/>
                  <a:pt x="327025" y="174626"/>
                </a:cubicBezTo>
                <a:cubicBezTo>
                  <a:pt x="330200" y="175684"/>
                  <a:pt x="333557" y="176304"/>
                  <a:pt x="336550" y="177801"/>
                </a:cubicBezTo>
                <a:cubicBezTo>
                  <a:pt x="339963" y="179508"/>
                  <a:pt x="342588" y="182601"/>
                  <a:pt x="346075" y="184151"/>
                </a:cubicBezTo>
                <a:cubicBezTo>
                  <a:pt x="352192" y="186869"/>
                  <a:pt x="359556" y="186788"/>
                  <a:pt x="365125" y="190501"/>
                </a:cubicBezTo>
                <a:cubicBezTo>
                  <a:pt x="376527" y="198102"/>
                  <a:pt x="377507" y="199962"/>
                  <a:pt x="393700" y="203201"/>
                </a:cubicBezTo>
                <a:cubicBezTo>
                  <a:pt x="431763" y="210814"/>
                  <a:pt x="414804" y="207777"/>
                  <a:pt x="444500" y="212726"/>
                </a:cubicBezTo>
                <a:cubicBezTo>
                  <a:pt x="467923" y="206870"/>
                  <a:pt x="447430" y="208665"/>
                  <a:pt x="466725" y="215901"/>
                </a:cubicBezTo>
                <a:cubicBezTo>
                  <a:pt x="473998" y="218628"/>
                  <a:pt x="504076" y="221761"/>
                  <a:pt x="508000" y="222251"/>
                </a:cubicBezTo>
                <a:lnTo>
                  <a:pt x="527050" y="228601"/>
                </a:lnTo>
                <a:cubicBezTo>
                  <a:pt x="530225" y="229659"/>
                  <a:pt x="533790" y="229920"/>
                  <a:pt x="536575" y="231776"/>
                </a:cubicBezTo>
                <a:cubicBezTo>
                  <a:pt x="563872" y="249974"/>
                  <a:pt x="529335" y="228156"/>
                  <a:pt x="555625" y="241301"/>
                </a:cubicBezTo>
                <a:cubicBezTo>
                  <a:pt x="559038" y="243008"/>
                  <a:pt x="561663" y="246101"/>
                  <a:pt x="565150" y="247651"/>
                </a:cubicBezTo>
                <a:cubicBezTo>
                  <a:pt x="571267" y="250369"/>
                  <a:pt x="577850" y="251884"/>
                  <a:pt x="584200" y="254001"/>
                </a:cubicBezTo>
                <a:cubicBezTo>
                  <a:pt x="587375" y="255059"/>
                  <a:pt x="590940" y="255320"/>
                  <a:pt x="593725" y="257176"/>
                </a:cubicBezTo>
                <a:lnTo>
                  <a:pt x="612775" y="269876"/>
                </a:lnTo>
                <a:cubicBezTo>
                  <a:pt x="614892" y="273051"/>
                  <a:pt x="616145" y="277017"/>
                  <a:pt x="619125" y="279401"/>
                </a:cubicBezTo>
                <a:cubicBezTo>
                  <a:pt x="621738" y="281492"/>
                  <a:pt x="625657" y="281079"/>
                  <a:pt x="628650" y="282576"/>
                </a:cubicBezTo>
                <a:cubicBezTo>
                  <a:pt x="632063" y="284283"/>
                  <a:pt x="635000" y="286809"/>
                  <a:pt x="638175" y="288926"/>
                </a:cubicBezTo>
                <a:cubicBezTo>
                  <a:pt x="640292" y="292101"/>
                  <a:pt x="642082" y="295520"/>
                  <a:pt x="644525" y="298451"/>
                </a:cubicBezTo>
                <a:cubicBezTo>
                  <a:pt x="647400" y="301900"/>
                  <a:pt x="651559" y="304240"/>
                  <a:pt x="654050" y="307976"/>
                </a:cubicBezTo>
                <a:cubicBezTo>
                  <a:pt x="655906" y="310761"/>
                  <a:pt x="655728" y="314508"/>
                  <a:pt x="657225" y="317501"/>
                </a:cubicBezTo>
                <a:cubicBezTo>
                  <a:pt x="658932" y="320914"/>
                  <a:pt x="661458" y="323851"/>
                  <a:pt x="663575" y="327026"/>
                </a:cubicBezTo>
                <a:cubicBezTo>
                  <a:pt x="664633" y="349251"/>
                  <a:pt x="665043" y="371516"/>
                  <a:pt x="666750" y="393701"/>
                </a:cubicBezTo>
                <a:cubicBezTo>
                  <a:pt x="667164" y="399082"/>
                  <a:pt x="668030" y="404523"/>
                  <a:pt x="669925" y="409576"/>
                </a:cubicBezTo>
                <a:cubicBezTo>
                  <a:pt x="675174" y="423573"/>
                  <a:pt x="675249" y="416414"/>
                  <a:pt x="685800" y="422276"/>
                </a:cubicBezTo>
                <a:cubicBezTo>
                  <a:pt x="692471" y="425982"/>
                  <a:pt x="704850" y="434976"/>
                  <a:pt x="704850" y="434976"/>
                </a:cubicBezTo>
                <a:cubicBezTo>
                  <a:pt x="706967" y="438151"/>
                  <a:pt x="708502" y="441803"/>
                  <a:pt x="711200" y="444501"/>
                </a:cubicBezTo>
                <a:cubicBezTo>
                  <a:pt x="720299" y="453600"/>
                  <a:pt x="719921" y="448861"/>
                  <a:pt x="730250" y="454026"/>
                </a:cubicBezTo>
                <a:cubicBezTo>
                  <a:pt x="733663" y="455733"/>
                  <a:pt x="736600" y="458259"/>
                  <a:pt x="739775" y="460376"/>
                </a:cubicBezTo>
                <a:cubicBezTo>
                  <a:pt x="756708" y="485776"/>
                  <a:pt x="734483" y="455084"/>
                  <a:pt x="755650" y="476251"/>
                </a:cubicBezTo>
                <a:cubicBezTo>
                  <a:pt x="758348" y="478949"/>
                  <a:pt x="759020" y="483392"/>
                  <a:pt x="762000" y="485776"/>
                </a:cubicBezTo>
                <a:cubicBezTo>
                  <a:pt x="764613" y="487867"/>
                  <a:pt x="768532" y="487454"/>
                  <a:pt x="771525" y="488951"/>
                </a:cubicBezTo>
                <a:cubicBezTo>
                  <a:pt x="774938" y="490658"/>
                  <a:pt x="778119" y="492858"/>
                  <a:pt x="781050" y="495301"/>
                </a:cubicBezTo>
                <a:cubicBezTo>
                  <a:pt x="810893" y="520170"/>
                  <a:pt x="761477" y="485428"/>
                  <a:pt x="809625" y="517526"/>
                </a:cubicBezTo>
                <a:cubicBezTo>
                  <a:pt x="812800" y="519643"/>
                  <a:pt x="815530" y="522669"/>
                  <a:pt x="819150" y="523876"/>
                </a:cubicBezTo>
                <a:lnTo>
                  <a:pt x="847725" y="533401"/>
                </a:lnTo>
                <a:lnTo>
                  <a:pt x="866775" y="539751"/>
                </a:lnTo>
                <a:cubicBezTo>
                  <a:pt x="869950" y="540809"/>
                  <a:pt x="873515" y="541070"/>
                  <a:pt x="876300" y="542926"/>
                </a:cubicBezTo>
                <a:cubicBezTo>
                  <a:pt x="879475" y="545043"/>
                  <a:pt x="882338" y="547726"/>
                  <a:pt x="885825" y="549276"/>
                </a:cubicBezTo>
                <a:cubicBezTo>
                  <a:pt x="891942" y="551994"/>
                  <a:pt x="904875" y="555626"/>
                  <a:pt x="904875" y="555626"/>
                </a:cubicBezTo>
                <a:cubicBezTo>
                  <a:pt x="915458" y="554568"/>
                  <a:pt x="926261" y="554843"/>
                  <a:pt x="936625" y="552451"/>
                </a:cubicBezTo>
                <a:cubicBezTo>
                  <a:pt x="947048" y="550046"/>
                  <a:pt x="954937" y="532920"/>
                  <a:pt x="958850" y="527051"/>
                </a:cubicBezTo>
                <a:lnTo>
                  <a:pt x="958850" y="527051"/>
                </a:lnTo>
                <a:lnTo>
                  <a:pt x="977900" y="520701"/>
                </a:lnTo>
                <a:cubicBezTo>
                  <a:pt x="981075" y="519643"/>
                  <a:pt x="984178" y="518338"/>
                  <a:pt x="987425" y="517526"/>
                </a:cubicBezTo>
                <a:lnTo>
                  <a:pt x="1000125" y="514351"/>
                </a:lnTo>
                <a:cubicBezTo>
                  <a:pt x="1007533" y="515409"/>
                  <a:pt x="1014968" y="516296"/>
                  <a:pt x="1022350" y="517526"/>
                </a:cubicBezTo>
                <a:cubicBezTo>
                  <a:pt x="1034442" y="519541"/>
                  <a:pt x="1039508" y="521022"/>
                  <a:pt x="1050925" y="523876"/>
                </a:cubicBezTo>
                <a:cubicBezTo>
                  <a:pt x="1074349" y="522074"/>
                  <a:pt x="1089911" y="522099"/>
                  <a:pt x="1111250" y="517526"/>
                </a:cubicBezTo>
                <a:cubicBezTo>
                  <a:pt x="1119784" y="515697"/>
                  <a:pt x="1128371" y="513936"/>
                  <a:pt x="1136650" y="511176"/>
                </a:cubicBezTo>
                <a:cubicBezTo>
                  <a:pt x="1139825" y="510118"/>
                  <a:pt x="1143182" y="509498"/>
                  <a:pt x="1146175" y="508001"/>
                </a:cubicBezTo>
                <a:cubicBezTo>
                  <a:pt x="1149588" y="506294"/>
                  <a:pt x="1152525" y="503768"/>
                  <a:pt x="1155700" y="501651"/>
                </a:cubicBezTo>
                <a:cubicBezTo>
                  <a:pt x="1158911" y="496835"/>
                  <a:pt x="1165225" y="489174"/>
                  <a:pt x="1165225" y="482601"/>
                </a:cubicBezTo>
                <a:cubicBezTo>
                  <a:pt x="1165225" y="475314"/>
                  <a:pt x="1160885" y="465561"/>
                  <a:pt x="1155700" y="460376"/>
                </a:cubicBezTo>
                <a:cubicBezTo>
                  <a:pt x="1153002" y="457678"/>
                  <a:pt x="1149350" y="456143"/>
                  <a:pt x="1146175" y="454026"/>
                </a:cubicBezTo>
                <a:cubicBezTo>
                  <a:pt x="1143670" y="446510"/>
                  <a:pt x="1139825" y="436289"/>
                  <a:pt x="1139825" y="428626"/>
                </a:cubicBezTo>
                <a:cubicBezTo>
                  <a:pt x="1139825" y="423230"/>
                  <a:pt x="1139184" y="416567"/>
                  <a:pt x="1143000" y="412751"/>
                </a:cubicBezTo>
                <a:cubicBezTo>
                  <a:pt x="1147733" y="408018"/>
                  <a:pt x="1162050" y="406401"/>
                  <a:pt x="1162050" y="406401"/>
                </a:cubicBezTo>
                <a:cubicBezTo>
                  <a:pt x="1164167" y="400051"/>
                  <a:pt x="1167087" y="393915"/>
                  <a:pt x="1168400" y="387351"/>
                </a:cubicBezTo>
                <a:cubicBezTo>
                  <a:pt x="1170405" y="377325"/>
                  <a:pt x="1173589" y="362291"/>
                  <a:pt x="1174750" y="352426"/>
                </a:cubicBezTo>
                <a:cubicBezTo>
                  <a:pt x="1176116" y="340816"/>
                  <a:pt x="1175894" y="329013"/>
                  <a:pt x="1177925" y="317501"/>
                </a:cubicBezTo>
                <a:cubicBezTo>
                  <a:pt x="1179088" y="310909"/>
                  <a:pt x="1180562" y="304020"/>
                  <a:pt x="1184275" y="298451"/>
                </a:cubicBezTo>
                <a:lnTo>
                  <a:pt x="1196975" y="279401"/>
                </a:lnTo>
                <a:cubicBezTo>
                  <a:pt x="1190849" y="248773"/>
                  <a:pt x="1198351" y="275802"/>
                  <a:pt x="1187450" y="254001"/>
                </a:cubicBezTo>
                <a:cubicBezTo>
                  <a:pt x="1185953" y="251008"/>
                  <a:pt x="1185900" y="247402"/>
                  <a:pt x="1184275" y="244476"/>
                </a:cubicBezTo>
                <a:cubicBezTo>
                  <a:pt x="1166079" y="211724"/>
                  <a:pt x="1175584" y="237454"/>
                  <a:pt x="1168400" y="215901"/>
                </a:cubicBezTo>
                <a:cubicBezTo>
                  <a:pt x="1167342" y="208493"/>
                  <a:pt x="1166455" y="201058"/>
                  <a:pt x="1165225" y="193676"/>
                </a:cubicBezTo>
                <a:cubicBezTo>
                  <a:pt x="1163580" y="183806"/>
                  <a:pt x="1158812" y="174721"/>
                  <a:pt x="1165225" y="165101"/>
                </a:cubicBezTo>
                <a:cubicBezTo>
                  <a:pt x="1169293" y="158999"/>
                  <a:pt x="1178359" y="158112"/>
                  <a:pt x="1184275" y="155576"/>
                </a:cubicBezTo>
                <a:cubicBezTo>
                  <a:pt x="1188625" y="153712"/>
                  <a:pt x="1192742" y="151343"/>
                  <a:pt x="1196975" y="149226"/>
                </a:cubicBezTo>
                <a:cubicBezTo>
                  <a:pt x="1199092" y="146051"/>
                  <a:pt x="1201822" y="143208"/>
                  <a:pt x="1203325" y="139701"/>
                </a:cubicBezTo>
                <a:cubicBezTo>
                  <a:pt x="1205044" y="135690"/>
                  <a:pt x="1205301" y="131197"/>
                  <a:pt x="1206500" y="127001"/>
                </a:cubicBezTo>
                <a:cubicBezTo>
                  <a:pt x="1207419" y="123783"/>
                  <a:pt x="1208756" y="120694"/>
                  <a:pt x="1209675" y="117476"/>
                </a:cubicBezTo>
                <a:cubicBezTo>
                  <a:pt x="1210642" y="114091"/>
                  <a:pt x="1213786" y="99281"/>
                  <a:pt x="1216025" y="95251"/>
                </a:cubicBezTo>
                <a:cubicBezTo>
                  <a:pt x="1219731" y="88580"/>
                  <a:pt x="1222375" y="80434"/>
                  <a:pt x="1228725" y="76201"/>
                </a:cubicBezTo>
                <a:cubicBezTo>
                  <a:pt x="1231900" y="74084"/>
                  <a:pt x="1234763" y="71401"/>
                  <a:pt x="1238250" y="69851"/>
                </a:cubicBezTo>
                <a:cubicBezTo>
                  <a:pt x="1244367" y="67133"/>
                  <a:pt x="1250950" y="65618"/>
                  <a:pt x="1257300" y="63501"/>
                </a:cubicBezTo>
                <a:lnTo>
                  <a:pt x="1266825" y="60326"/>
                </a:lnTo>
                <a:cubicBezTo>
                  <a:pt x="1270000" y="59268"/>
                  <a:pt x="1273103" y="57963"/>
                  <a:pt x="1276350" y="57151"/>
                </a:cubicBezTo>
                <a:cubicBezTo>
                  <a:pt x="1292297" y="53164"/>
                  <a:pt x="1284910" y="55356"/>
                  <a:pt x="1298575" y="50801"/>
                </a:cubicBezTo>
                <a:cubicBezTo>
                  <a:pt x="1312333" y="51859"/>
                  <a:pt x="1326220" y="51824"/>
                  <a:pt x="1339850" y="53976"/>
                </a:cubicBezTo>
                <a:cubicBezTo>
                  <a:pt x="1346462" y="55020"/>
                  <a:pt x="1352550" y="58209"/>
                  <a:pt x="1358900" y="60326"/>
                </a:cubicBezTo>
                <a:lnTo>
                  <a:pt x="1368425" y="63501"/>
                </a:lnTo>
                <a:cubicBezTo>
                  <a:pt x="1386417" y="62443"/>
                  <a:pt x="1404467" y="62119"/>
                  <a:pt x="1422400" y="60326"/>
                </a:cubicBezTo>
                <a:cubicBezTo>
                  <a:pt x="1425730" y="59993"/>
                  <a:pt x="1428999" y="58776"/>
                  <a:pt x="1431925" y="57151"/>
                </a:cubicBezTo>
                <a:cubicBezTo>
                  <a:pt x="1438596" y="53445"/>
                  <a:pt x="1444625" y="48684"/>
                  <a:pt x="1450975" y="44451"/>
                </a:cubicBezTo>
                <a:lnTo>
                  <a:pt x="1460500" y="38101"/>
                </a:lnTo>
                <a:cubicBezTo>
                  <a:pt x="1463675" y="35984"/>
                  <a:pt x="1466405" y="32958"/>
                  <a:pt x="1470025" y="31751"/>
                </a:cubicBezTo>
                <a:lnTo>
                  <a:pt x="1498600" y="22226"/>
                </a:lnTo>
                <a:cubicBezTo>
                  <a:pt x="1501775" y="21168"/>
                  <a:pt x="1504878" y="19863"/>
                  <a:pt x="1508125" y="19051"/>
                </a:cubicBezTo>
                <a:cubicBezTo>
                  <a:pt x="1516592" y="16934"/>
                  <a:pt x="1525246" y="15461"/>
                  <a:pt x="1533525" y="12701"/>
                </a:cubicBezTo>
                <a:cubicBezTo>
                  <a:pt x="1551116" y="6837"/>
                  <a:pt x="1546775" y="7847"/>
                  <a:pt x="1574800" y="3176"/>
                </a:cubicBezTo>
                <a:cubicBezTo>
                  <a:pt x="1594894" y="-173"/>
                  <a:pt x="1587412" y="1"/>
                  <a:pt x="1597025" y="1"/>
                </a:cubicBezTo>
              </a:path>
            </a:pathLst>
          </a:custGeom>
          <a:ln w="6350" cmpd="sng">
            <a:solidFill>
              <a:srgbClr val="FFFFFF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reeform 15"/>
          <p:cNvSpPr/>
          <p:nvPr/>
        </p:nvSpPr>
        <p:spPr>
          <a:xfrm>
            <a:off x="1695450" y="8235950"/>
            <a:ext cx="1546225" cy="1114425"/>
          </a:xfrm>
          <a:custGeom>
            <a:avLst/>
            <a:gdLst>
              <a:gd name="connsiteX0" fmla="*/ 0 w 1546225"/>
              <a:gd name="connsiteY0" fmla="*/ 1114425 h 1114425"/>
              <a:gd name="connsiteX1" fmla="*/ 15875 w 1546225"/>
              <a:gd name="connsiteY1" fmla="*/ 1101725 h 1114425"/>
              <a:gd name="connsiteX2" fmla="*/ 31750 w 1546225"/>
              <a:gd name="connsiteY2" fmla="*/ 1085850 h 1114425"/>
              <a:gd name="connsiteX3" fmla="*/ 38100 w 1546225"/>
              <a:gd name="connsiteY3" fmla="*/ 1066800 h 1114425"/>
              <a:gd name="connsiteX4" fmla="*/ 41275 w 1546225"/>
              <a:gd name="connsiteY4" fmla="*/ 1057275 h 1114425"/>
              <a:gd name="connsiteX5" fmla="*/ 53975 w 1546225"/>
              <a:gd name="connsiteY5" fmla="*/ 1038225 h 1114425"/>
              <a:gd name="connsiteX6" fmla="*/ 60325 w 1546225"/>
              <a:gd name="connsiteY6" fmla="*/ 1028700 h 1114425"/>
              <a:gd name="connsiteX7" fmla="*/ 69850 w 1546225"/>
              <a:gd name="connsiteY7" fmla="*/ 1019175 h 1114425"/>
              <a:gd name="connsiteX8" fmla="*/ 98425 w 1546225"/>
              <a:gd name="connsiteY8" fmla="*/ 996950 h 1114425"/>
              <a:gd name="connsiteX9" fmla="*/ 117475 w 1546225"/>
              <a:gd name="connsiteY9" fmla="*/ 958850 h 1114425"/>
              <a:gd name="connsiteX10" fmla="*/ 123825 w 1546225"/>
              <a:gd name="connsiteY10" fmla="*/ 949325 h 1114425"/>
              <a:gd name="connsiteX11" fmla="*/ 142875 w 1546225"/>
              <a:gd name="connsiteY11" fmla="*/ 936625 h 1114425"/>
              <a:gd name="connsiteX12" fmla="*/ 149225 w 1546225"/>
              <a:gd name="connsiteY12" fmla="*/ 927100 h 1114425"/>
              <a:gd name="connsiteX13" fmla="*/ 168275 w 1546225"/>
              <a:gd name="connsiteY13" fmla="*/ 914400 h 1114425"/>
              <a:gd name="connsiteX14" fmla="*/ 184150 w 1546225"/>
              <a:gd name="connsiteY14" fmla="*/ 901700 h 1114425"/>
              <a:gd name="connsiteX15" fmla="*/ 193675 w 1546225"/>
              <a:gd name="connsiteY15" fmla="*/ 892175 h 1114425"/>
              <a:gd name="connsiteX16" fmla="*/ 203200 w 1546225"/>
              <a:gd name="connsiteY16" fmla="*/ 885825 h 1114425"/>
              <a:gd name="connsiteX17" fmla="*/ 219075 w 1546225"/>
              <a:gd name="connsiteY17" fmla="*/ 873125 h 1114425"/>
              <a:gd name="connsiteX18" fmla="*/ 238125 w 1546225"/>
              <a:gd name="connsiteY18" fmla="*/ 860425 h 1114425"/>
              <a:gd name="connsiteX19" fmla="*/ 247650 w 1546225"/>
              <a:gd name="connsiteY19" fmla="*/ 854075 h 1114425"/>
              <a:gd name="connsiteX20" fmla="*/ 257175 w 1546225"/>
              <a:gd name="connsiteY20" fmla="*/ 850900 h 1114425"/>
              <a:gd name="connsiteX21" fmla="*/ 266700 w 1546225"/>
              <a:gd name="connsiteY21" fmla="*/ 844550 h 1114425"/>
              <a:gd name="connsiteX22" fmla="*/ 285750 w 1546225"/>
              <a:gd name="connsiteY22" fmla="*/ 838200 h 1114425"/>
              <a:gd name="connsiteX23" fmla="*/ 304800 w 1546225"/>
              <a:gd name="connsiteY23" fmla="*/ 822325 h 1114425"/>
              <a:gd name="connsiteX24" fmla="*/ 314325 w 1546225"/>
              <a:gd name="connsiteY24" fmla="*/ 819150 h 1114425"/>
              <a:gd name="connsiteX25" fmla="*/ 333375 w 1546225"/>
              <a:gd name="connsiteY25" fmla="*/ 809625 h 1114425"/>
              <a:gd name="connsiteX26" fmla="*/ 349250 w 1546225"/>
              <a:gd name="connsiteY26" fmla="*/ 796925 h 1114425"/>
              <a:gd name="connsiteX27" fmla="*/ 377825 w 1546225"/>
              <a:gd name="connsiteY27" fmla="*/ 774700 h 1114425"/>
              <a:gd name="connsiteX28" fmla="*/ 396875 w 1546225"/>
              <a:gd name="connsiteY28" fmla="*/ 736600 h 1114425"/>
              <a:gd name="connsiteX29" fmla="*/ 403225 w 1546225"/>
              <a:gd name="connsiteY29" fmla="*/ 727075 h 1114425"/>
              <a:gd name="connsiteX30" fmla="*/ 409575 w 1546225"/>
              <a:gd name="connsiteY30" fmla="*/ 717550 h 1114425"/>
              <a:gd name="connsiteX31" fmla="*/ 419100 w 1546225"/>
              <a:gd name="connsiteY31" fmla="*/ 714375 h 1114425"/>
              <a:gd name="connsiteX32" fmla="*/ 438150 w 1546225"/>
              <a:gd name="connsiteY32" fmla="*/ 701675 h 1114425"/>
              <a:gd name="connsiteX33" fmla="*/ 457200 w 1546225"/>
              <a:gd name="connsiteY33" fmla="*/ 692150 h 1114425"/>
              <a:gd name="connsiteX34" fmla="*/ 482600 w 1546225"/>
              <a:gd name="connsiteY34" fmla="*/ 669925 h 1114425"/>
              <a:gd name="connsiteX35" fmla="*/ 492125 w 1546225"/>
              <a:gd name="connsiteY35" fmla="*/ 663575 h 1114425"/>
              <a:gd name="connsiteX36" fmla="*/ 501650 w 1546225"/>
              <a:gd name="connsiteY36" fmla="*/ 660400 h 1114425"/>
              <a:gd name="connsiteX37" fmla="*/ 530225 w 1546225"/>
              <a:gd name="connsiteY37" fmla="*/ 644525 h 1114425"/>
              <a:gd name="connsiteX38" fmla="*/ 565150 w 1546225"/>
              <a:gd name="connsiteY38" fmla="*/ 641350 h 1114425"/>
              <a:gd name="connsiteX39" fmla="*/ 600075 w 1546225"/>
              <a:gd name="connsiteY39" fmla="*/ 631825 h 1114425"/>
              <a:gd name="connsiteX40" fmla="*/ 609600 w 1546225"/>
              <a:gd name="connsiteY40" fmla="*/ 628650 h 1114425"/>
              <a:gd name="connsiteX41" fmla="*/ 619125 w 1546225"/>
              <a:gd name="connsiteY41" fmla="*/ 609600 h 1114425"/>
              <a:gd name="connsiteX42" fmla="*/ 628650 w 1546225"/>
              <a:gd name="connsiteY42" fmla="*/ 603250 h 1114425"/>
              <a:gd name="connsiteX43" fmla="*/ 638175 w 1546225"/>
              <a:gd name="connsiteY43" fmla="*/ 600075 h 1114425"/>
              <a:gd name="connsiteX44" fmla="*/ 650875 w 1546225"/>
              <a:gd name="connsiteY44" fmla="*/ 581025 h 1114425"/>
              <a:gd name="connsiteX45" fmla="*/ 688975 w 1546225"/>
              <a:gd name="connsiteY45" fmla="*/ 574675 h 1114425"/>
              <a:gd name="connsiteX46" fmla="*/ 698500 w 1546225"/>
              <a:gd name="connsiteY46" fmla="*/ 571500 h 1114425"/>
              <a:gd name="connsiteX47" fmla="*/ 704850 w 1546225"/>
              <a:gd name="connsiteY47" fmla="*/ 561975 h 1114425"/>
              <a:gd name="connsiteX48" fmla="*/ 714375 w 1546225"/>
              <a:gd name="connsiteY48" fmla="*/ 555625 h 1114425"/>
              <a:gd name="connsiteX49" fmla="*/ 727075 w 1546225"/>
              <a:gd name="connsiteY49" fmla="*/ 536575 h 1114425"/>
              <a:gd name="connsiteX50" fmla="*/ 739775 w 1546225"/>
              <a:gd name="connsiteY50" fmla="*/ 517525 h 1114425"/>
              <a:gd name="connsiteX51" fmla="*/ 746125 w 1546225"/>
              <a:gd name="connsiteY51" fmla="*/ 508000 h 1114425"/>
              <a:gd name="connsiteX52" fmla="*/ 755650 w 1546225"/>
              <a:gd name="connsiteY52" fmla="*/ 501650 h 1114425"/>
              <a:gd name="connsiteX53" fmla="*/ 758825 w 1546225"/>
              <a:gd name="connsiteY53" fmla="*/ 492125 h 1114425"/>
              <a:gd name="connsiteX54" fmla="*/ 777875 w 1546225"/>
              <a:gd name="connsiteY54" fmla="*/ 482600 h 1114425"/>
              <a:gd name="connsiteX55" fmla="*/ 796925 w 1546225"/>
              <a:gd name="connsiteY55" fmla="*/ 469900 h 1114425"/>
              <a:gd name="connsiteX56" fmla="*/ 806450 w 1546225"/>
              <a:gd name="connsiteY56" fmla="*/ 463550 h 1114425"/>
              <a:gd name="connsiteX57" fmla="*/ 844550 w 1546225"/>
              <a:gd name="connsiteY57" fmla="*/ 454025 h 1114425"/>
              <a:gd name="connsiteX58" fmla="*/ 876300 w 1546225"/>
              <a:gd name="connsiteY58" fmla="*/ 444500 h 1114425"/>
              <a:gd name="connsiteX59" fmla="*/ 911225 w 1546225"/>
              <a:gd name="connsiteY59" fmla="*/ 441325 h 1114425"/>
              <a:gd name="connsiteX60" fmla="*/ 977900 w 1546225"/>
              <a:gd name="connsiteY60" fmla="*/ 438150 h 1114425"/>
              <a:gd name="connsiteX61" fmla="*/ 1000125 w 1546225"/>
              <a:gd name="connsiteY61" fmla="*/ 431800 h 1114425"/>
              <a:gd name="connsiteX62" fmla="*/ 1025525 w 1546225"/>
              <a:gd name="connsiteY62" fmla="*/ 434975 h 1114425"/>
              <a:gd name="connsiteX63" fmla="*/ 1101725 w 1546225"/>
              <a:gd name="connsiteY63" fmla="*/ 434975 h 1114425"/>
              <a:gd name="connsiteX64" fmla="*/ 1120775 w 1546225"/>
              <a:gd name="connsiteY64" fmla="*/ 428625 h 1114425"/>
              <a:gd name="connsiteX65" fmla="*/ 1127125 w 1546225"/>
              <a:gd name="connsiteY65" fmla="*/ 419100 h 1114425"/>
              <a:gd name="connsiteX66" fmla="*/ 1136650 w 1546225"/>
              <a:gd name="connsiteY66" fmla="*/ 412750 h 1114425"/>
              <a:gd name="connsiteX67" fmla="*/ 1149350 w 1546225"/>
              <a:gd name="connsiteY67" fmla="*/ 393700 h 1114425"/>
              <a:gd name="connsiteX68" fmla="*/ 1177925 w 1546225"/>
              <a:gd name="connsiteY68" fmla="*/ 368300 h 1114425"/>
              <a:gd name="connsiteX69" fmla="*/ 1200150 w 1546225"/>
              <a:gd name="connsiteY69" fmla="*/ 371475 h 1114425"/>
              <a:gd name="connsiteX70" fmla="*/ 1209675 w 1546225"/>
              <a:gd name="connsiteY70" fmla="*/ 374650 h 1114425"/>
              <a:gd name="connsiteX71" fmla="*/ 1216025 w 1546225"/>
              <a:gd name="connsiteY71" fmla="*/ 384175 h 1114425"/>
              <a:gd name="connsiteX72" fmla="*/ 1222375 w 1546225"/>
              <a:gd name="connsiteY72" fmla="*/ 450850 h 1114425"/>
              <a:gd name="connsiteX73" fmla="*/ 1228725 w 1546225"/>
              <a:gd name="connsiteY73" fmla="*/ 469900 h 1114425"/>
              <a:gd name="connsiteX74" fmla="*/ 1241425 w 1546225"/>
              <a:gd name="connsiteY74" fmla="*/ 488950 h 1114425"/>
              <a:gd name="connsiteX75" fmla="*/ 1260475 w 1546225"/>
              <a:gd name="connsiteY75" fmla="*/ 495300 h 1114425"/>
              <a:gd name="connsiteX76" fmla="*/ 1270000 w 1546225"/>
              <a:gd name="connsiteY76" fmla="*/ 498475 h 1114425"/>
              <a:gd name="connsiteX77" fmla="*/ 1282700 w 1546225"/>
              <a:gd name="connsiteY77" fmla="*/ 501650 h 1114425"/>
              <a:gd name="connsiteX78" fmla="*/ 1301750 w 1546225"/>
              <a:gd name="connsiteY78" fmla="*/ 508000 h 1114425"/>
              <a:gd name="connsiteX79" fmla="*/ 1323975 w 1546225"/>
              <a:gd name="connsiteY79" fmla="*/ 504825 h 1114425"/>
              <a:gd name="connsiteX80" fmla="*/ 1336675 w 1546225"/>
              <a:gd name="connsiteY80" fmla="*/ 488950 h 1114425"/>
              <a:gd name="connsiteX81" fmla="*/ 1352550 w 1546225"/>
              <a:gd name="connsiteY81" fmla="*/ 469900 h 1114425"/>
              <a:gd name="connsiteX82" fmla="*/ 1362075 w 1546225"/>
              <a:gd name="connsiteY82" fmla="*/ 450850 h 1114425"/>
              <a:gd name="connsiteX83" fmla="*/ 1390650 w 1546225"/>
              <a:gd name="connsiteY83" fmla="*/ 438150 h 1114425"/>
              <a:gd name="connsiteX84" fmla="*/ 1400175 w 1546225"/>
              <a:gd name="connsiteY84" fmla="*/ 434975 h 1114425"/>
              <a:gd name="connsiteX85" fmla="*/ 1419225 w 1546225"/>
              <a:gd name="connsiteY85" fmla="*/ 428625 h 1114425"/>
              <a:gd name="connsiteX86" fmla="*/ 1428750 w 1546225"/>
              <a:gd name="connsiteY86" fmla="*/ 425450 h 1114425"/>
              <a:gd name="connsiteX87" fmla="*/ 1441450 w 1546225"/>
              <a:gd name="connsiteY87" fmla="*/ 396875 h 1114425"/>
              <a:gd name="connsiteX88" fmla="*/ 1444625 w 1546225"/>
              <a:gd name="connsiteY88" fmla="*/ 387350 h 1114425"/>
              <a:gd name="connsiteX89" fmla="*/ 1454150 w 1546225"/>
              <a:gd name="connsiteY89" fmla="*/ 330200 h 1114425"/>
              <a:gd name="connsiteX90" fmla="*/ 1460500 w 1546225"/>
              <a:gd name="connsiteY90" fmla="*/ 320675 h 1114425"/>
              <a:gd name="connsiteX91" fmla="*/ 1479550 w 1546225"/>
              <a:gd name="connsiteY91" fmla="*/ 311150 h 1114425"/>
              <a:gd name="connsiteX92" fmla="*/ 1466850 w 1546225"/>
              <a:gd name="connsiteY92" fmla="*/ 298450 h 1114425"/>
              <a:gd name="connsiteX93" fmla="*/ 1457325 w 1546225"/>
              <a:gd name="connsiteY93" fmla="*/ 288925 h 1114425"/>
              <a:gd name="connsiteX94" fmla="*/ 1444625 w 1546225"/>
              <a:gd name="connsiteY94" fmla="*/ 285750 h 1114425"/>
              <a:gd name="connsiteX95" fmla="*/ 1425575 w 1546225"/>
              <a:gd name="connsiteY95" fmla="*/ 276225 h 1114425"/>
              <a:gd name="connsiteX96" fmla="*/ 1403350 w 1546225"/>
              <a:gd name="connsiteY96" fmla="*/ 247650 h 1114425"/>
              <a:gd name="connsiteX97" fmla="*/ 1381125 w 1546225"/>
              <a:gd name="connsiteY97" fmla="*/ 219075 h 1114425"/>
              <a:gd name="connsiteX98" fmla="*/ 1374775 w 1546225"/>
              <a:gd name="connsiteY98" fmla="*/ 209550 h 1114425"/>
              <a:gd name="connsiteX99" fmla="*/ 1368425 w 1546225"/>
              <a:gd name="connsiteY99" fmla="*/ 200025 h 1114425"/>
              <a:gd name="connsiteX100" fmla="*/ 1362075 w 1546225"/>
              <a:gd name="connsiteY100" fmla="*/ 180975 h 1114425"/>
              <a:gd name="connsiteX101" fmla="*/ 1358900 w 1546225"/>
              <a:gd name="connsiteY101" fmla="*/ 171450 h 1114425"/>
              <a:gd name="connsiteX102" fmla="*/ 1355725 w 1546225"/>
              <a:gd name="connsiteY102" fmla="*/ 155575 h 1114425"/>
              <a:gd name="connsiteX103" fmla="*/ 1355725 w 1546225"/>
              <a:gd name="connsiteY103" fmla="*/ 63500 h 1114425"/>
              <a:gd name="connsiteX104" fmla="*/ 1358900 w 1546225"/>
              <a:gd name="connsiteY104" fmla="*/ 53975 h 1114425"/>
              <a:gd name="connsiteX105" fmla="*/ 1387475 w 1546225"/>
              <a:gd name="connsiteY105" fmla="*/ 38100 h 1114425"/>
              <a:gd name="connsiteX106" fmla="*/ 1406525 w 1546225"/>
              <a:gd name="connsiteY106" fmla="*/ 25400 h 1114425"/>
              <a:gd name="connsiteX107" fmla="*/ 1416050 w 1546225"/>
              <a:gd name="connsiteY107" fmla="*/ 22225 h 1114425"/>
              <a:gd name="connsiteX108" fmla="*/ 1425575 w 1546225"/>
              <a:gd name="connsiteY108" fmla="*/ 15875 h 1114425"/>
              <a:gd name="connsiteX109" fmla="*/ 1463675 w 1546225"/>
              <a:gd name="connsiteY109" fmla="*/ 9525 h 1114425"/>
              <a:gd name="connsiteX110" fmla="*/ 1482725 w 1546225"/>
              <a:gd name="connsiteY110" fmla="*/ 3175 h 1114425"/>
              <a:gd name="connsiteX111" fmla="*/ 1492250 w 1546225"/>
              <a:gd name="connsiteY111" fmla="*/ 0 h 1114425"/>
              <a:gd name="connsiteX112" fmla="*/ 1501775 w 1546225"/>
              <a:gd name="connsiteY112" fmla="*/ 6350 h 1114425"/>
              <a:gd name="connsiteX113" fmla="*/ 1511300 w 1546225"/>
              <a:gd name="connsiteY113" fmla="*/ 9525 h 1114425"/>
              <a:gd name="connsiteX114" fmla="*/ 1517650 w 1546225"/>
              <a:gd name="connsiteY114" fmla="*/ 19050 h 1114425"/>
              <a:gd name="connsiteX115" fmla="*/ 1536700 w 1546225"/>
              <a:gd name="connsiteY115" fmla="*/ 31750 h 1114425"/>
              <a:gd name="connsiteX116" fmla="*/ 1546225 w 1546225"/>
              <a:gd name="connsiteY116" fmla="*/ 41275 h 1114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</a:cxnLst>
            <a:rect l="l" t="t" r="r" b="b"/>
            <a:pathLst>
              <a:path w="1546225" h="1114425">
                <a:moveTo>
                  <a:pt x="0" y="1114425"/>
                </a:moveTo>
                <a:cubicBezTo>
                  <a:pt x="5292" y="1110192"/>
                  <a:pt x="11083" y="1106517"/>
                  <a:pt x="15875" y="1101725"/>
                </a:cubicBezTo>
                <a:cubicBezTo>
                  <a:pt x="37042" y="1080558"/>
                  <a:pt x="6350" y="1102783"/>
                  <a:pt x="31750" y="1085850"/>
                </a:cubicBezTo>
                <a:lnTo>
                  <a:pt x="38100" y="1066800"/>
                </a:lnTo>
                <a:cubicBezTo>
                  <a:pt x="39158" y="1063625"/>
                  <a:pt x="39419" y="1060060"/>
                  <a:pt x="41275" y="1057275"/>
                </a:cubicBezTo>
                <a:lnTo>
                  <a:pt x="53975" y="1038225"/>
                </a:lnTo>
                <a:cubicBezTo>
                  <a:pt x="56092" y="1035050"/>
                  <a:pt x="57627" y="1031398"/>
                  <a:pt x="60325" y="1028700"/>
                </a:cubicBezTo>
                <a:cubicBezTo>
                  <a:pt x="63500" y="1025525"/>
                  <a:pt x="66306" y="1021932"/>
                  <a:pt x="69850" y="1019175"/>
                </a:cubicBezTo>
                <a:cubicBezTo>
                  <a:pt x="104029" y="992591"/>
                  <a:pt x="76800" y="1018575"/>
                  <a:pt x="98425" y="996950"/>
                </a:cubicBezTo>
                <a:cubicBezTo>
                  <a:pt x="107188" y="970660"/>
                  <a:pt x="101062" y="983469"/>
                  <a:pt x="117475" y="958850"/>
                </a:cubicBezTo>
                <a:cubicBezTo>
                  <a:pt x="119592" y="955675"/>
                  <a:pt x="120650" y="951442"/>
                  <a:pt x="123825" y="949325"/>
                </a:cubicBezTo>
                <a:lnTo>
                  <a:pt x="142875" y="936625"/>
                </a:lnTo>
                <a:cubicBezTo>
                  <a:pt x="144992" y="933450"/>
                  <a:pt x="146353" y="929613"/>
                  <a:pt x="149225" y="927100"/>
                </a:cubicBezTo>
                <a:cubicBezTo>
                  <a:pt x="154968" y="922074"/>
                  <a:pt x="168275" y="914400"/>
                  <a:pt x="168275" y="914400"/>
                </a:cubicBezTo>
                <a:cubicBezTo>
                  <a:pt x="182477" y="893098"/>
                  <a:pt x="165747" y="913969"/>
                  <a:pt x="184150" y="901700"/>
                </a:cubicBezTo>
                <a:cubicBezTo>
                  <a:pt x="187886" y="899209"/>
                  <a:pt x="190226" y="895050"/>
                  <a:pt x="193675" y="892175"/>
                </a:cubicBezTo>
                <a:cubicBezTo>
                  <a:pt x="196606" y="889732"/>
                  <a:pt x="200025" y="887942"/>
                  <a:pt x="203200" y="885825"/>
                </a:cubicBezTo>
                <a:cubicBezTo>
                  <a:pt x="214933" y="868226"/>
                  <a:pt x="202837" y="882146"/>
                  <a:pt x="219075" y="873125"/>
                </a:cubicBezTo>
                <a:cubicBezTo>
                  <a:pt x="225746" y="869419"/>
                  <a:pt x="231775" y="864658"/>
                  <a:pt x="238125" y="860425"/>
                </a:cubicBezTo>
                <a:cubicBezTo>
                  <a:pt x="241300" y="858308"/>
                  <a:pt x="244030" y="855282"/>
                  <a:pt x="247650" y="854075"/>
                </a:cubicBezTo>
                <a:cubicBezTo>
                  <a:pt x="250825" y="853017"/>
                  <a:pt x="254182" y="852397"/>
                  <a:pt x="257175" y="850900"/>
                </a:cubicBezTo>
                <a:cubicBezTo>
                  <a:pt x="260588" y="849193"/>
                  <a:pt x="263213" y="846100"/>
                  <a:pt x="266700" y="844550"/>
                </a:cubicBezTo>
                <a:cubicBezTo>
                  <a:pt x="272817" y="841832"/>
                  <a:pt x="285750" y="838200"/>
                  <a:pt x="285750" y="838200"/>
                </a:cubicBezTo>
                <a:cubicBezTo>
                  <a:pt x="292772" y="831178"/>
                  <a:pt x="295959" y="826745"/>
                  <a:pt x="304800" y="822325"/>
                </a:cubicBezTo>
                <a:cubicBezTo>
                  <a:pt x="307793" y="820828"/>
                  <a:pt x="311332" y="820647"/>
                  <a:pt x="314325" y="819150"/>
                </a:cubicBezTo>
                <a:cubicBezTo>
                  <a:pt x="338944" y="806840"/>
                  <a:pt x="309434" y="817605"/>
                  <a:pt x="333375" y="809625"/>
                </a:cubicBezTo>
                <a:cubicBezTo>
                  <a:pt x="345108" y="792026"/>
                  <a:pt x="333012" y="805946"/>
                  <a:pt x="349250" y="796925"/>
                </a:cubicBezTo>
                <a:cubicBezTo>
                  <a:pt x="366340" y="787431"/>
                  <a:pt x="366255" y="786270"/>
                  <a:pt x="377825" y="774700"/>
                </a:cubicBezTo>
                <a:cubicBezTo>
                  <a:pt x="386588" y="748410"/>
                  <a:pt x="380462" y="761219"/>
                  <a:pt x="396875" y="736600"/>
                </a:cubicBezTo>
                <a:lnTo>
                  <a:pt x="403225" y="727075"/>
                </a:lnTo>
                <a:cubicBezTo>
                  <a:pt x="405342" y="723900"/>
                  <a:pt x="405955" y="718757"/>
                  <a:pt x="409575" y="717550"/>
                </a:cubicBezTo>
                <a:cubicBezTo>
                  <a:pt x="412750" y="716492"/>
                  <a:pt x="416174" y="716000"/>
                  <a:pt x="419100" y="714375"/>
                </a:cubicBezTo>
                <a:cubicBezTo>
                  <a:pt x="425771" y="710669"/>
                  <a:pt x="430910" y="704088"/>
                  <a:pt x="438150" y="701675"/>
                </a:cubicBezTo>
                <a:cubicBezTo>
                  <a:pt x="451295" y="697293"/>
                  <a:pt x="444890" y="700356"/>
                  <a:pt x="457200" y="692150"/>
                </a:cubicBezTo>
                <a:cubicBezTo>
                  <a:pt x="467783" y="676275"/>
                  <a:pt x="460375" y="684742"/>
                  <a:pt x="482600" y="669925"/>
                </a:cubicBezTo>
                <a:cubicBezTo>
                  <a:pt x="485775" y="667808"/>
                  <a:pt x="488505" y="664782"/>
                  <a:pt x="492125" y="663575"/>
                </a:cubicBezTo>
                <a:cubicBezTo>
                  <a:pt x="495300" y="662517"/>
                  <a:pt x="498724" y="662025"/>
                  <a:pt x="501650" y="660400"/>
                </a:cubicBezTo>
                <a:cubicBezTo>
                  <a:pt x="511718" y="654806"/>
                  <a:pt x="518620" y="646183"/>
                  <a:pt x="530225" y="644525"/>
                </a:cubicBezTo>
                <a:cubicBezTo>
                  <a:pt x="541797" y="642872"/>
                  <a:pt x="553508" y="642408"/>
                  <a:pt x="565150" y="641350"/>
                </a:cubicBezTo>
                <a:cubicBezTo>
                  <a:pt x="587589" y="636862"/>
                  <a:pt x="575905" y="639882"/>
                  <a:pt x="600075" y="631825"/>
                </a:cubicBezTo>
                <a:lnTo>
                  <a:pt x="609600" y="628650"/>
                </a:lnTo>
                <a:cubicBezTo>
                  <a:pt x="612182" y="620903"/>
                  <a:pt x="612970" y="615755"/>
                  <a:pt x="619125" y="609600"/>
                </a:cubicBezTo>
                <a:cubicBezTo>
                  <a:pt x="621823" y="606902"/>
                  <a:pt x="625237" y="604957"/>
                  <a:pt x="628650" y="603250"/>
                </a:cubicBezTo>
                <a:cubicBezTo>
                  <a:pt x="631643" y="601753"/>
                  <a:pt x="635000" y="601133"/>
                  <a:pt x="638175" y="600075"/>
                </a:cubicBezTo>
                <a:cubicBezTo>
                  <a:pt x="640554" y="592938"/>
                  <a:pt x="641956" y="583998"/>
                  <a:pt x="650875" y="581025"/>
                </a:cubicBezTo>
                <a:cubicBezTo>
                  <a:pt x="663089" y="576954"/>
                  <a:pt x="676761" y="578746"/>
                  <a:pt x="688975" y="574675"/>
                </a:cubicBezTo>
                <a:lnTo>
                  <a:pt x="698500" y="571500"/>
                </a:lnTo>
                <a:cubicBezTo>
                  <a:pt x="700617" y="568325"/>
                  <a:pt x="702152" y="564673"/>
                  <a:pt x="704850" y="561975"/>
                </a:cubicBezTo>
                <a:cubicBezTo>
                  <a:pt x="707548" y="559277"/>
                  <a:pt x="711862" y="558497"/>
                  <a:pt x="714375" y="555625"/>
                </a:cubicBezTo>
                <a:cubicBezTo>
                  <a:pt x="719401" y="549882"/>
                  <a:pt x="722842" y="542925"/>
                  <a:pt x="727075" y="536575"/>
                </a:cubicBezTo>
                <a:lnTo>
                  <a:pt x="739775" y="517525"/>
                </a:lnTo>
                <a:cubicBezTo>
                  <a:pt x="741892" y="514350"/>
                  <a:pt x="742950" y="510117"/>
                  <a:pt x="746125" y="508000"/>
                </a:cubicBezTo>
                <a:lnTo>
                  <a:pt x="755650" y="501650"/>
                </a:lnTo>
                <a:cubicBezTo>
                  <a:pt x="756708" y="498475"/>
                  <a:pt x="756734" y="494738"/>
                  <a:pt x="758825" y="492125"/>
                </a:cubicBezTo>
                <a:cubicBezTo>
                  <a:pt x="765591" y="483668"/>
                  <a:pt x="769592" y="487201"/>
                  <a:pt x="777875" y="482600"/>
                </a:cubicBezTo>
                <a:cubicBezTo>
                  <a:pt x="784546" y="478894"/>
                  <a:pt x="790575" y="474133"/>
                  <a:pt x="796925" y="469900"/>
                </a:cubicBezTo>
                <a:cubicBezTo>
                  <a:pt x="800100" y="467783"/>
                  <a:pt x="802830" y="464757"/>
                  <a:pt x="806450" y="463550"/>
                </a:cubicBezTo>
                <a:cubicBezTo>
                  <a:pt x="858279" y="446274"/>
                  <a:pt x="793245" y="466851"/>
                  <a:pt x="844550" y="454025"/>
                </a:cubicBezTo>
                <a:cubicBezTo>
                  <a:pt x="854862" y="451447"/>
                  <a:pt x="865502" y="445940"/>
                  <a:pt x="876300" y="444500"/>
                </a:cubicBezTo>
                <a:cubicBezTo>
                  <a:pt x="887887" y="442955"/>
                  <a:pt x="899558" y="442054"/>
                  <a:pt x="911225" y="441325"/>
                </a:cubicBezTo>
                <a:cubicBezTo>
                  <a:pt x="933432" y="439937"/>
                  <a:pt x="955675" y="439208"/>
                  <a:pt x="977900" y="438150"/>
                </a:cubicBezTo>
                <a:cubicBezTo>
                  <a:pt x="982392" y="436653"/>
                  <a:pt x="996138" y="431800"/>
                  <a:pt x="1000125" y="431800"/>
                </a:cubicBezTo>
                <a:cubicBezTo>
                  <a:pt x="1008658" y="431800"/>
                  <a:pt x="1017058" y="433917"/>
                  <a:pt x="1025525" y="434975"/>
                </a:cubicBezTo>
                <a:cubicBezTo>
                  <a:pt x="1054654" y="444685"/>
                  <a:pt x="1041710" y="441643"/>
                  <a:pt x="1101725" y="434975"/>
                </a:cubicBezTo>
                <a:cubicBezTo>
                  <a:pt x="1108378" y="434236"/>
                  <a:pt x="1120775" y="428625"/>
                  <a:pt x="1120775" y="428625"/>
                </a:cubicBezTo>
                <a:cubicBezTo>
                  <a:pt x="1122892" y="425450"/>
                  <a:pt x="1124427" y="421798"/>
                  <a:pt x="1127125" y="419100"/>
                </a:cubicBezTo>
                <a:cubicBezTo>
                  <a:pt x="1129823" y="416402"/>
                  <a:pt x="1134137" y="415622"/>
                  <a:pt x="1136650" y="412750"/>
                </a:cubicBezTo>
                <a:cubicBezTo>
                  <a:pt x="1141676" y="407007"/>
                  <a:pt x="1143954" y="399096"/>
                  <a:pt x="1149350" y="393700"/>
                </a:cubicBezTo>
                <a:cubicBezTo>
                  <a:pt x="1171098" y="371952"/>
                  <a:pt x="1160928" y="379631"/>
                  <a:pt x="1177925" y="368300"/>
                </a:cubicBezTo>
                <a:cubicBezTo>
                  <a:pt x="1185333" y="369358"/>
                  <a:pt x="1192812" y="370007"/>
                  <a:pt x="1200150" y="371475"/>
                </a:cubicBezTo>
                <a:cubicBezTo>
                  <a:pt x="1203432" y="372131"/>
                  <a:pt x="1207062" y="372559"/>
                  <a:pt x="1209675" y="374650"/>
                </a:cubicBezTo>
                <a:cubicBezTo>
                  <a:pt x="1212655" y="377034"/>
                  <a:pt x="1213908" y="381000"/>
                  <a:pt x="1216025" y="384175"/>
                </a:cubicBezTo>
                <a:cubicBezTo>
                  <a:pt x="1217026" y="399193"/>
                  <a:pt x="1217637" y="431899"/>
                  <a:pt x="1222375" y="450850"/>
                </a:cubicBezTo>
                <a:cubicBezTo>
                  <a:pt x="1223998" y="457344"/>
                  <a:pt x="1225012" y="464331"/>
                  <a:pt x="1228725" y="469900"/>
                </a:cubicBezTo>
                <a:cubicBezTo>
                  <a:pt x="1232958" y="476250"/>
                  <a:pt x="1234185" y="486537"/>
                  <a:pt x="1241425" y="488950"/>
                </a:cubicBezTo>
                <a:lnTo>
                  <a:pt x="1260475" y="495300"/>
                </a:lnTo>
                <a:cubicBezTo>
                  <a:pt x="1263650" y="496358"/>
                  <a:pt x="1266753" y="497663"/>
                  <a:pt x="1270000" y="498475"/>
                </a:cubicBezTo>
                <a:cubicBezTo>
                  <a:pt x="1274233" y="499533"/>
                  <a:pt x="1278520" y="500396"/>
                  <a:pt x="1282700" y="501650"/>
                </a:cubicBezTo>
                <a:cubicBezTo>
                  <a:pt x="1289111" y="503573"/>
                  <a:pt x="1301750" y="508000"/>
                  <a:pt x="1301750" y="508000"/>
                </a:cubicBezTo>
                <a:cubicBezTo>
                  <a:pt x="1309158" y="506942"/>
                  <a:pt x="1316807" y="506975"/>
                  <a:pt x="1323975" y="504825"/>
                </a:cubicBezTo>
                <a:cubicBezTo>
                  <a:pt x="1336568" y="501047"/>
                  <a:pt x="1332044" y="498211"/>
                  <a:pt x="1336675" y="488950"/>
                </a:cubicBezTo>
                <a:cubicBezTo>
                  <a:pt x="1341095" y="480109"/>
                  <a:pt x="1345528" y="476922"/>
                  <a:pt x="1352550" y="469900"/>
                </a:cubicBezTo>
                <a:cubicBezTo>
                  <a:pt x="1355132" y="462153"/>
                  <a:pt x="1355920" y="457005"/>
                  <a:pt x="1362075" y="450850"/>
                </a:cubicBezTo>
                <a:cubicBezTo>
                  <a:pt x="1369622" y="443303"/>
                  <a:pt x="1381219" y="441294"/>
                  <a:pt x="1390650" y="438150"/>
                </a:cubicBezTo>
                <a:lnTo>
                  <a:pt x="1400175" y="434975"/>
                </a:lnTo>
                <a:lnTo>
                  <a:pt x="1419225" y="428625"/>
                </a:lnTo>
                <a:lnTo>
                  <a:pt x="1428750" y="425450"/>
                </a:lnTo>
                <a:cubicBezTo>
                  <a:pt x="1438813" y="410356"/>
                  <a:pt x="1433893" y="419545"/>
                  <a:pt x="1441450" y="396875"/>
                </a:cubicBezTo>
                <a:lnTo>
                  <a:pt x="1444625" y="387350"/>
                </a:lnTo>
                <a:cubicBezTo>
                  <a:pt x="1445533" y="376459"/>
                  <a:pt x="1445253" y="343546"/>
                  <a:pt x="1454150" y="330200"/>
                </a:cubicBezTo>
                <a:cubicBezTo>
                  <a:pt x="1456267" y="327025"/>
                  <a:pt x="1457802" y="323373"/>
                  <a:pt x="1460500" y="320675"/>
                </a:cubicBezTo>
                <a:cubicBezTo>
                  <a:pt x="1466655" y="314520"/>
                  <a:pt x="1471803" y="313732"/>
                  <a:pt x="1479550" y="311150"/>
                </a:cubicBezTo>
                <a:cubicBezTo>
                  <a:pt x="1473502" y="293007"/>
                  <a:pt x="1481364" y="308126"/>
                  <a:pt x="1466850" y="298450"/>
                </a:cubicBezTo>
                <a:cubicBezTo>
                  <a:pt x="1463114" y="295959"/>
                  <a:pt x="1461224" y="291153"/>
                  <a:pt x="1457325" y="288925"/>
                </a:cubicBezTo>
                <a:cubicBezTo>
                  <a:pt x="1453536" y="286760"/>
                  <a:pt x="1448821" y="286949"/>
                  <a:pt x="1444625" y="285750"/>
                </a:cubicBezTo>
                <a:cubicBezTo>
                  <a:pt x="1435909" y="283260"/>
                  <a:pt x="1432835" y="282275"/>
                  <a:pt x="1425575" y="276225"/>
                </a:cubicBezTo>
                <a:cubicBezTo>
                  <a:pt x="1398763" y="253881"/>
                  <a:pt x="1438751" y="283051"/>
                  <a:pt x="1403350" y="247650"/>
                </a:cubicBezTo>
                <a:cubicBezTo>
                  <a:pt x="1388429" y="232729"/>
                  <a:pt x="1396316" y="241861"/>
                  <a:pt x="1381125" y="219075"/>
                </a:cubicBezTo>
                <a:lnTo>
                  <a:pt x="1374775" y="209550"/>
                </a:lnTo>
                <a:cubicBezTo>
                  <a:pt x="1372658" y="206375"/>
                  <a:pt x="1369632" y="203645"/>
                  <a:pt x="1368425" y="200025"/>
                </a:cubicBezTo>
                <a:lnTo>
                  <a:pt x="1362075" y="180975"/>
                </a:lnTo>
                <a:cubicBezTo>
                  <a:pt x="1361017" y="177800"/>
                  <a:pt x="1359556" y="174732"/>
                  <a:pt x="1358900" y="171450"/>
                </a:cubicBezTo>
                <a:lnTo>
                  <a:pt x="1355725" y="155575"/>
                </a:lnTo>
                <a:cubicBezTo>
                  <a:pt x="1351936" y="110107"/>
                  <a:pt x="1350553" y="115217"/>
                  <a:pt x="1355725" y="63500"/>
                </a:cubicBezTo>
                <a:cubicBezTo>
                  <a:pt x="1356058" y="60170"/>
                  <a:pt x="1356533" y="56342"/>
                  <a:pt x="1358900" y="53975"/>
                </a:cubicBezTo>
                <a:cubicBezTo>
                  <a:pt x="1383474" y="29401"/>
                  <a:pt x="1369509" y="48081"/>
                  <a:pt x="1387475" y="38100"/>
                </a:cubicBezTo>
                <a:cubicBezTo>
                  <a:pt x="1394146" y="34394"/>
                  <a:pt x="1399285" y="27813"/>
                  <a:pt x="1406525" y="25400"/>
                </a:cubicBezTo>
                <a:cubicBezTo>
                  <a:pt x="1409700" y="24342"/>
                  <a:pt x="1413057" y="23722"/>
                  <a:pt x="1416050" y="22225"/>
                </a:cubicBezTo>
                <a:cubicBezTo>
                  <a:pt x="1419463" y="20518"/>
                  <a:pt x="1421888" y="16858"/>
                  <a:pt x="1425575" y="15875"/>
                </a:cubicBezTo>
                <a:cubicBezTo>
                  <a:pt x="1438015" y="12558"/>
                  <a:pt x="1451461" y="13596"/>
                  <a:pt x="1463675" y="9525"/>
                </a:cubicBezTo>
                <a:lnTo>
                  <a:pt x="1482725" y="3175"/>
                </a:lnTo>
                <a:lnTo>
                  <a:pt x="1492250" y="0"/>
                </a:lnTo>
                <a:cubicBezTo>
                  <a:pt x="1495425" y="2117"/>
                  <a:pt x="1498362" y="4643"/>
                  <a:pt x="1501775" y="6350"/>
                </a:cubicBezTo>
                <a:cubicBezTo>
                  <a:pt x="1504768" y="7847"/>
                  <a:pt x="1508687" y="7434"/>
                  <a:pt x="1511300" y="9525"/>
                </a:cubicBezTo>
                <a:cubicBezTo>
                  <a:pt x="1514280" y="11909"/>
                  <a:pt x="1514778" y="16537"/>
                  <a:pt x="1517650" y="19050"/>
                </a:cubicBezTo>
                <a:cubicBezTo>
                  <a:pt x="1523393" y="24076"/>
                  <a:pt x="1531304" y="26354"/>
                  <a:pt x="1536700" y="31750"/>
                </a:cubicBezTo>
                <a:lnTo>
                  <a:pt x="1546225" y="41275"/>
                </a:lnTo>
              </a:path>
            </a:pathLst>
          </a:custGeom>
          <a:ln w="6350" cmpd="sng">
            <a:solidFill>
              <a:schemeClr val="bg1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Freeform 37"/>
          <p:cNvSpPr/>
          <p:nvPr/>
        </p:nvSpPr>
        <p:spPr>
          <a:xfrm>
            <a:off x="3373856" y="8235950"/>
            <a:ext cx="1546225" cy="1114425"/>
          </a:xfrm>
          <a:custGeom>
            <a:avLst/>
            <a:gdLst>
              <a:gd name="connsiteX0" fmla="*/ 0 w 1546225"/>
              <a:gd name="connsiteY0" fmla="*/ 1114425 h 1114425"/>
              <a:gd name="connsiteX1" fmla="*/ 15875 w 1546225"/>
              <a:gd name="connsiteY1" fmla="*/ 1101725 h 1114425"/>
              <a:gd name="connsiteX2" fmla="*/ 31750 w 1546225"/>
              <a:gd name="connsiteY2" fmla="*/ 1085850 h 1114425"/>
              <a:gd name="connsiteX3" fmla="*/ 38100 w 1546225"/>
              <a:gd name="connsiteY3" fmla="*/ 1066800 h 1114425"/>
              <a:gd name="connsiteX4" fmla="*/ 41275 w 1546225"/>
              <a:gd name="connsiteY4" fmla="*/ 1057275 h 1114425"/>
              <a:gd name="connsiteX5" fmla="*/ 53975 w 1546225"/>
              <a:gd name="connsiteY5" fmla="*/ 1038225 h 1114425"/>
              <a:gd name="connsiteX6" fmla="*/ 60325 w 1546225"/>
              <a:gd name="connsiteY6" fmla="*/ 1028700 h 1114425"/>
              <a:gd name="connsiteX7" fmla="*/ 69850 w 1546225"/>
              <a:gd name="connsiteY7" fmla="*/ 1019175 h 1114425"/>
              <a:gd name="connsiteX8" fmla="*/ 98425 w 1546225"/>
              <a:gd name="connsiteY8" fmla="*/ 996950 h 1114425"/>
              <a:gd name="connsiteX9" fmla="*/ 117475 w 1546225"/>
              <a:gd name="connsiteY9" fmla="*/ 958850 h 1114425"/>
              <a:gd name="connsiteX10" fmla="*/ 123825 w 1546225"/>
              <a:gd name="connsiteY10" fmla="*/ 949325 h 1114425"/>
              <a:gd name="connsiteX11" fmla="*/ 142875 w 1546225"/>
              <a:gd name="connsiteY11" fmla="*/ 936625 h 1114425"/>
              <a:gd name="connsiteX12" fmla="*/ 149225 w 1546225"/>
              <a:gd name="connsiteY12" fmla="*/ 927100 h 1114425"/>
              <a:gd name="connsiteX13" fmla="*/ 168275 w 1546225"/>
              <a:gd name="connsiteY13" fmla="*/ 914400 h 1114425"/>
              <a:gd name="connsiteX14" fmla="*/ 184150 w 1546225"/>
              <a:gd name="connsiteY14" fmla="*/ 901700 h 1114425"/>
              <a:gd name="connsiteX15" fmla="*/ 193675 w 1546225"/>
              <a:gd name="connsiteY15" fmla="*/ 892175 h 1114425"/>
              <a:gd name="connsiteX16" fmla="*/ 203200 w 1546225"/>
              <a:gd name="connsiteY16" fmla="*/ 885825 h 1114425"/>
              <a:gd name="connsiteX17" fmla="*/ 219075 w 1546225"/>
              <a:gd name="connsiteY17" fmla="*/ 873125 h 1114425"/>
              <a:gd name="connsiteX18" fmla="*/ 238125 w 1546225"/>
              <a:gd name="connsiteY18" fmla="*/ 860425 h 1114425"/>
              <a:gd name="connsiteX19" fmla="*/ 247650 w 1546225"/>
              <a:gd name="connsiteY19" fmla="*/ 854075 h 1114425"/>
              <a:gd name="connsiteX20" fmla="*/ 257175 w 1546225"/>
              <a:gd name="connsiteY20" fmla="*/ 850900 h 1114425"/>
              <a:gd name="connsiteX21" fmla="*/ 266700 w 1546225"/>
              <a:gd name="connsiteY21" fmla="*/ 844550 h 1114425"/>
              <a:gd name="connsiteX22" fmla="*/ 285750 w 1546225"/>
              <a:gd name="connsiteY22" fmla="*/ 838200 h 1114425"/>
              <a:gd name="connsiteX23" fmla="*/ 304800 w 1546225"/>
              <a:gd name="connsiteY23" fmla="*/ 822325 h 1114425"/>
              <a:gd name="connsiteX24" fmla="*/ 314325 w 1546225"/>
              <a:gd name="connsiteY24" fmla="*/ 819150 h 1114425"/>
              <a:gd name="connsiteX25" fmla="*/ 333375 w 1546225"/>
              <a:gd name="connsiteY25" fmla="*/ 809625 h 1114425"/>
              <a:gd name="connsiteX26" fmla="*/ 349250 w 1546225"/>
              <a:gd name="connsiteY26" fmla="*/ 796925 h 1114425"/>
              <a:gd name="connsiteX27" fmla="*/ 377825 w 1546225"/>
              <a:gd name="connsiteY27" fmla="*/ 774700 h 1114425"/>
              <a:gd name="connsiteX28" fmla="*/ 396875 w 1546225"/>
              <a:gd name="connsiteY28" fmla="*/ 736600 h 1114425"/>
              <a:gd name="connsiteX29" fmla="*/ 403225 w 1546225"/>
              <a:gd name="connsiteY29" fmla="*/ 727075 h 1114425"/>
              <a:gd name="connsiteX30" fmla="*/ 409575 w 1546225"/>
              <a:gd name="connsiteY30" fmla="*/ 717550 h 1114425"/>
              <a:gd name="connsiteX31" fmla="*/ 419100 w 1546225"/>
              <a:gd name="connsiteY31" fmla="*/ 714375 h 1114425"/>
              <a:gd name="connsiteX32" fmla="*/ 438150 w 1546225"/>
              <a:gd name="connsiteY32" fmla="*/ 701675 h 1114425"/>
              <a:gd name="connsiteX33" fmla="*/ 457200 w 1546225"/>
              <a:gd name="connsiteY33" fmla="*/ 692150 h 1114425"/>
              <a:gd name="connsiteX34" fmla="*/ 482600 w 1546225"/>
              <a:gd name="connsiteY34" fmla="*/ 669925 h 1114425"/>
              <a:gd name="connsiteX35" fmla="*/ 492125 w 1546225"/>
              <a:gd name="connsiteY35" fmla="*/ 663575 h 1114425"/>
              <a:gd name="connsiteX36" fmla="*/ 501650 w 1546225"/>
              <a:gd name="connsiteY36" fmla="*/ 660400 h 1114425"/>
              <a:gd name="connsiteX37" fmla="*/ 530225 w 1546225"/>
              <a:gd name="connsiteY37" fmla="*/ 644525 h 1114425"/>
              <a:gd name="connsiteX38" fmla="*/ 565150 w 1546225"/>
              <a:gd name="connsiteY38" fmla="*/ 641350 h 1114425"/>
              <a:gd name="connsiteX39" fmla="*/ 600075 w 1546225"/>
              <a:gd name="connsiteY39" fmla="*/ 631825 h 1114425"/>
              <a:gd name="connsiteX40" fmla="*/ 609600 w 1546225"/>
              <a:gd name="connsiteY40" fmla="*/ 628650 h 1114425"/>
              <a:gd name="connsiteX41" fmla="*/ 619125 w 1546225"/>
              <a:gd name="connsiteY41" fmla="*/ 609600 h 1114425"/>
              <a:gd name="connsiteX42" fmla="*/ 628650 w 1546225"/>
              <a:gd name="connsiteY42" fmla="*/ 603250 h 1114425"/>
              <a:gd name="connsiteX43" fmla="*/ 638175 w 1546225"/>
              <a:gd name="connsiteY43" fmla="*/ 600075 h 1114425"/>
              <a:gd name="connsiteX44" fmla="*/ 650875 w 1546225"/>
              <a:gd name="connsiteY44" fmla="*/ 581025 h 1114425"/>
              <a:gd name="connsiteX45" fmla="*/ 688975 w 1546225"/>
              <a:gd name="connsiteY45" fmla="*/ 574675 h 1114425"/>
              <a:gd name="connsiteX46" fmla="*/ 698500 w 1546225"/>
              <a:gd name="connsiteY46" fmla="*/ 571500 h 1114425"/>
              <a:gd name="connsiteX47" fmla="*/ 704850 w 1546225"/>
              <a:gd name="connsiteY47" fmla="*/ 561975 h 1114425"/>
              <a:gd name="connsiteX48" fmla="*/ 714375 w 1546225"/>
              <a:gd name="connsiteY48" fmla="*/ 555625 h 1114425"/>
              <a:gd name="connsiteX49" fmla="*/ 727075 w 1546225"/>
              <a:gd name="connsiteY49" fmla="*/ 536575 h 1114425"/>
              <a:gd name="connsiteX50" fmla="*/ 739775 w 1546225"/>
              <a:gd name="connsiteY50" fmla="*/ 517525 h 1114425"/>
              <a:gd name="connsiteX51" fmla="*/ 746125 w 1546225"/>
              <a:gd name="connsiteY51" fmla="*/ 508000 h 1114425"/>
              <a:gd name="connsiteX52" fmla="*/ 755650 w 1546225"/>
              <a:gd name="connsiteY52" fmla="*/ 501650 h 1114425"/>
              <a:gd name="connsiteX53" fmla="*/ 758825 w 1546225"/>
              <a:gd name="connsiteY53" fmla="*/ 492125 h 1114425"/>
              <a:gd name="connsiteX54" fmla="*/ 777875 w 1546225"/>
              <a:gd name="connsiteY54" fmla="*/ 482600 h 1114425"/>
              <a:gd name="connsiteX55" fmla="*/ 796925 w 1546225"/>
              <a:gd name="connsiteY55" fmla="*/ 469900 h 1114425"/>
              <a:gd name="connsiteX56" fmla="*/ 806450 w 1546225"/>
              <a:gd name="connsiteY56" fmla="*/ 463550 h 1114425"/>
              <a:gd name="connsiteX57" fmla="*/ 844550 w 1546225"/>
              <a:gd name="connsiteY57" fmla="*/ 454025 h 1114425"/>
              <a:gd name="connsiteX58" fmla="*/ 876300 w 1546225"/>
              <a:gd name="connsiteY58" fmla="*/ 444500 h 1114425"/>
              <a:gd name="connsiteX59" fmla="*/ 911225 w 1546225"/>
              <a:gd name="connsiteY59" fmla="*/ 441325 h 1114425"/>
              <a:gd name="connsiteX60" fmla="*/ 977900 w 1546225"/>
              <a:gd name="connsiteY60" fmla="*/ 438150 h 1114425"/>
              <a:gd name="connsiteX61" fmla="*/ 1000125 w 1546225"/>
              <a:gd name="connsiteY61" fmla="*/ 431800 h 1114425"/>
              <a:gd name="connsiteX62" fmla="*/ 1025525 w 1546225"/>
              <a:gd name="connsiteY62" fmla="*/ 434975 h 1114425"/>
              <a:gd name="connsiteX63" fmla="*/ 1101725 w 1546225"/>
              <a:gd name="connsiteY63" fmla="*/ 434975 h 1114425"/>
              <a:gd name="connsiteX64" fmla="*/ 1120775 w 1546225"/>
              <a:gd name="connsiteY64" fmla="*/ 428625 h 1114425"/>
              <a:gd name="connsiteX65" fmla="*/ 1127125 w 1546225"/>
              <a:gd name="connsiteY65" fmla="*/ 419100 h 1114425"/>
              <a:gd name="connsiteX66" fmla="*/ 1136650 w 1546225"/>
              <a:gd name="connsiteY66" fmla="*/ 412750 h 1114425"/>
              <a:gd name="connsiteX67" fmla="*/ 1149350 w 1546225"/>
              <a:gd name="connsiteY67" fmla="*/ 393700 h 1114425"/>
              <a:gd name="connsiteX68" fmla="*/ 1177925 w 1546225"/>
              <a:gd name="connsiteY68" fmla="*/ 368300 h 1114425"/>
              <a:gd name="connsiteX69" fmla="*/ 1200150 w 1546225"/>
              <a:gd name="connsiteY69" fmla="*/ 371475 h 1114425"/>
              <a:gd name="connsiteX70" fmla="*/ 1209675 w 1546225"/>
              <a:gd name="connsiteY70" fmla="*/ 374650 h 1114425"/>
              <a:gd name="connsiteX71" fmla="*/ 1216025 w 1546225"/>
              <a:gd name="connsiteY71" fmla="*/ 384175 h 1114425"/>
              <a:gd name="connsiteX72" fmla="*/ 1222375 w 1546225"/>
              <a:gd name="connsiteY72" fmla="*/ 450850 h 1114425"/>
              <a:gd name="connsiteX73" fmla="*/ 1228725 w 1546225"/>
              <a:gd name="connsiteY73" fmla="*/ 469900 h 1114425"/>
              <a:gd name="connsiteX74" fmla="*/ 1241425 w 1546225"/>
              <a:gd name="connsiteY74" fmla="*/ 488950 h 1114425"/>
              <a:gd name="connsiteX75" fmla="*/ 1260475 w 1546225"/>
              <a:gd name="connsiteY75" fmla="*/ 495300 h 1114425"/>
              <a:gd name="connsiteX76" fmla="*/ 1270000 w 1546225"/>
              <a:gd name="connsiteY76" fmla="*/ 498475 h 1114425"/>
              <a:gd name="connsiteX77" fmla="*/ 1282700 w 1546225"/>
              <a:gd name="connsiteY77" fmla="*/ 501650 h 1114425"/>
              <a:gd name="connsiteX78" fmla="*/ 1301750 w 1546225"/>
              <a:gd name="connsiteY78" fmla="*/ 508000 h 1114425"/>
              <a:gd name="connsiteX79" fmla="*/ 1323975 w 1546225"/>
              <a:gd name="connsiteY79" fmla="*/ 504825 h 1114425"/>
              <a:gd name="connsiteX80" fmla="*/ 1336675 w 1546225"/>
              <a:gd name="connsiteY80" fmla="*/ 488950 h 1114425"/>
              <a:gd name="connsiteX81" fmla="*/ 1352550 w 1546225"/>
              <a:gd name="connsiteY81" fmla="*/ 469900 h 1114425"/>
              <a:gd name="connsiteX82" fmla="*/ 1362075 w 1546225"/>
              <a:gd name="connsiteY82" fmla="*/ 450850 h 1114425"/>
              <a:gd name="connsiteX83" fmla="*/ 1390650 w 1546225"/>
              <a:gd name="connsiteY83" fmla="*/ 438150 h 1114425"/>
              <a:gd name="connsiteX84" fmla="*/ 1400175 w 1546225"/>
              <a:gd name="connsiteY84" fmla="*/ 434975 h 1114425"/>
              <a:gd name="connsiteX85" fmla="*/ 1419225 w 1546225"/>
              <a:gd name="connsiteY85" fmla="*/ 428625 h 1114425"/>
              <a:gd name="connsiteX86" fmla="*/ 1428750 w 1546225"/>
              <a:gd name="connsiteY86" fmla="*/ 425450 h 1114425"/>
              <a:gd name="connsiteX87" fmla="*/ 1441450 w 1546225"/>
              <a:gd name="connsiteY87" fmla="*/ 396875 h 1114425"/>
              <a:gd name="connsiteX88" fmla="*/ 1444625 w 1546225"/>
              <a:gd name="connsiteY88" fmla="*/ 387350 h 1114425"/>
              <a:gd name="connsiteX89" fmla="*/ 1454150 w 1546225"/>
              <a:gd name="connsiteY89" fmla="*/ 330200 h 1114425"/>
              <a:gd name="connsiteX90" fmla="*/ 1460500 w 1546225"/>
              <a:gd name="connsiteY90" fmla="*/ 320675 h 1114425"/>
              <a:gd name="connsiteX91" fmla="*/ 1479550 w 1546225"/>
              <a:gd name="connsiteY91" fmla="*/ 311150 h 1114425"/>
              <a:gd name="connsiteX92" fmla="*/ 1466850 w 1546225"/>
              <a:gd name="connsiteY92" fmla="*/ 298450 h 1114425"/>
              <a:gd name="connsiteX93" fmla="*/ 1457325 w 1546225"/>
              <a:gd name="connsiteY93" fmla="*/ 288925 h 1114425"/>
              <a:gd name="connsiteX94" fmla="*/ 1444625 w 1546225"/>
              <a:gd name="connsiteY94" fmla="*/ 285750 h 1114425"/>
              <a:gd name="connsiteX95" fmla="*/ 1425575 w 1546225"/>
              <a:gd name="connsiteY95" fmla="*/ 276225 h 1114425"/>
              <a:gd name="connsiteX96" fmla="*/ 1403350 w 1546225"/>
              <a:gd name="connsiteY96" fmla="*/ 247650 h 1114425"/>
              <a:gd name="connsiteX97" fmla="*/ 1381125 w 1546225"/>
              <a:gd name="connsiteY97" fmla="*/ 219075 h 1114425"/>
              <a:gd name="connsiteX98" fmla="*/ 1374775 w 1546225"/>
              <a:gd name="connsiteY98" fmla="*/ 209550 h 1114425"/>
              <a:gd name="connsiteX99" fmla="*/ 1368425 w 1546225"/>
              <a:gd name="connsiteY99" fmla="*/ 200025 h 1114425"/>
              <a:gd name="connsiteX100" fmla="*/ 1362075 w 1546225"/>
              <a:gd name="connsiteY100" fmla="*/ 180975 h 1114425"/>
              <a:gd name="connsiteX101" fmla="*/ 1358900 w 1546225"/>
              <a:gd name="connsiteY101" fmla="*/ 171450 h 1114425"/>
              <a:gd name="connsiteX102" fmla="*/ 1355725 w 1546225"/>
              <a:gd name="connsiteY102" fmla="*/ 155575 h 1114425"/>
              <a:gd name="connsiteX103" fmla="*/ 1355725 w 1546225"/>
              <a:gd name="connsiteY103" fmla="*/ 63500 h 1114425"/>
              <a:gd name="connsiteX104" fmla="*/ 1358900 w 1546225"/>
              <a:gd name="connsiteY104" fmla="*/ 53975 h 1114425"/>
              <a:gd name="connsiteX105" fmla="*/ 1387475 w 1546225"/>
              <a:gd name="connsiteY105" fmla="*/ 38100 h 1114425"/>
              <a:gd name="connsiteX106" fmla="*/ 1406525 w 1546225"/>
              <a:gd name="connsiteY106" fmla="*/ 25400 h 1114425"/>
              <a:gd name="connsiteX107" fmla="*/ 1416050 w 1546225"/>
              <a:gd name="connsiteY107" fmla="*/ 22225 h 1114425"/>
              <a:gd name="connsiteX108" fmla="*/ 1425575 w 1546225"/>
              <a:gd name="connsiteY108" fmla="*/ 15875 h 1114425"/>
              <a:gd name="connsiteX109" fmla="*/ 1463675 w 1546225"/>
              <a:gd name="connsiteY109" fmla="*/ 9525 h 1114425"/>
              <a:gd name="connsiteX110" fmla="*/ 1482725 w 1546225"/>
              <a:gd name="connsiteY110" fmla="*/ 3175 h 1114425"/>
              <a:gd name="connsiteX111" fmla="*/ 1492250 w 1546225"/>
              <a:gd name="connsiteY111" fmla="*/ 0 h 1114425"/>
              <a:gd name="connsiteX112" fmla="*/ 1501775 w 1546225"/>
              <a:gd name="connsiteY112" fmla="*/ 6350 h 1114425"/>
              <a:gd name="connsiteX113" fmla="*/ 1511300 w 1546225"/>
              <a:gd name="connsiteY113" fmla="*/ 9525 h 1114425"/>
              <a:gd name="connsiteX114" fmla="*/ 1517650 w 1546225"/>
              <a:gd name="connsiteY114" fmla="*/ 19050 h 1114425"/>
              <a:gd name="connsiteX115" fmla="*/ 1536700 w 1546225"/>
              <a:gd name="connsiteY115" fmla="*/ 31750 h 1114425"/>
              <a:gd name="connsiteX116" fmla="*/ 1546225 w 1546225"/>
              <a:gd name="connsiteY116" fmla="*/ 41275 h 1114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</a:cxnLst>
            <a:rect l="l" t="t" r="r" b="b"/>
            <a:pathLst>
              <a:path w="1546225" h="1114425">
                <a:moveTo>
                  <a:pt x="0" y="1114425"/>
                </a:moveTo>
                <a:cubicBezTo>
                  <a:pt x="5292" y="1110192"/>
                  <a:pt x="11083" y="1106517"/>
                  <a:pt x="15875" y="1101725"/>
                </a:cubicBezTo>
                <a:cubicBezTo>
                  <a:pt x="37042" y="1080558"/>
                  <a:pt x="6350" y="1102783"/>
                  <a:pt x="31750" y="1085850"/>
                </a:cubicBezTo>
                <a:lnTo>
                  <a:pt x="38100" y="1066800"/>
                </a:lnTo>
                <a:cubicBezTo>
                  <a:pt x="39158" y="1063625"/>
                  <a:pt x="39419" y="1060060"/>
                  <a:pt x="41275" y="1057275"/>
                </a:cubicBezTo>
                <a:lnTo>
                  <a:pt x="53975" y="1038225"/>
                </a:lnTo>
                <a:cubicBezTo>
                  <a:pt x="56092" y="1035050"/>
                  <a:pt x="57627" y="1031398"/>
                  <a:pt x="60325" y="1028700"/>
                </a:cubicBezTo>
                <a:cubicBezTo>
                  <a:pt x="63500" y="1025525"/>
                  <a:pt x="66306" y="1021932"/>
                  <a:pt x="69850" y="1019175"/>
                </a:cubicBezTo>
                <a:cubicBezTo>
                  <a:pt x="104029" y="992591"/>
                  <a:pt x="76800" y="1018575"/>
                  <a:pt x="98425" y="996950"/>
                </a:cubicBezTo>
                <a:cubicBezTo>
                  <a:pt x="107188" y="970660"/>
                  <a:pt x="101062" y="983469"/>
                  <a:pt x="117475" y="958850"/>
                </a:cubicBezTo>
                <a:cubicBezTo>
                  <a:pt x="119592" y="955675"/>
                  <a:pt x="120650" y="951442"/>
                  <a:pt x="123825" y="949325"/>
                </a:cubicBezTo>
                <a:lnTo>
                  <a:pt x="142875" y="936625"/>
                </a:lnTo>
                <a:cubicBezTo>
                  <a:pt x="144992" y="933450"/>
                  <a:pt x="146353" y="929613"/>
                  <a:pt x="149225" y="927100"/>
                </a:cubicBezTo>
                <a:cubicBezTo>
                  <a:pt x="154968" y="922074"/>
                  <a:pt x="168275" y="914400"/>
                  <a:pt x="168275" y="914400"/>
                </a:cubicBezTo>
                <a:cubicBezTo>
                  <a:pt x="182477" y="893098"/>
                  <a:pt x="165747" y="913969"/>
                  <a:pt x="184150" y="901700"/>
                </a:cubicBezTo>
                <a:cubicBezTo>
                  <a:pt x="187886" y="899209"/>
                  <a:pt x="190226" y="895050"/>
                  <a:pt x="193675" y="892175"/>
                </a:cubicBezTo>
                <a:cubicBezTo>
                  <a:pt x="196606" y="889732"/>
                  <a:pt x="200025" y="887942"/>
                  <a:pt x="203200" y="885825"/>
                </a:cubicBezTo>
                <a:cubicBezTo>
                  <a:pt x="214933" y="868226"/>
                  <a:pt x="202837" y="882146"/>
                  <a:pt x="219075" y="873125"/>
                </a:cubicBezTo>
                <a:cubicBezTo>
                  <a:pt x="225746" y="869419"/>
                  <a:pt x="231775" y="864658"/>
                  <a:pt x="238125" y="860425"/>
                </a:cubicBezTo>
                <a:cubicBezTo>
                  <a:pt x="241300" y="858308"/>
                  <a:pt x="244030" y="855282"/>
                  <a:pt x="247650" y="854075"/>
                </a:cubicBezTo>
                <a:cubicBezTo>
                  <a:pt x="250825" y="853017"/>
                  <a:pt x="254182" y="852397"/>
                  <a:pt x="257175" y="850900"/>
                </a:cubicBezTo>
                <a:cubicBezTo>
                  <a:pt x="260588" y="849193"/>
                  <a:pt x="263213" y="846100"/>
                  <a:pt x="266700" y="844550"/>
                </a:cubicBezTo>
                <a:cubicBezTo>
                  <a:pt x="272817" y="841832"/>
                  <a:pt x="285750" y="838200"/>
                  <a:pt x="285750" y="838200"/>
                </a:cubicBezTo>
                <a:cubicBezTo>
                  <a:pt x="292772" y="831178"/>
                  <a:pt x="295959" y="826745"/>
                  <a:pt x="304800" y="822325"/>
                </a:cubicBezTo>
                <a:cubicBezTo>
                  <a:pt x="307793" y="820828"/>
                  <a:pt x="311332" y="820647"/>
                  <a:pt x="314325" y="819150"/>
                </a:cubicBezTo>
                <a:cubicBezTo>
                  <a:pt x="338944" y="806840"/>
                  <a:pt x="309434" y="817605"/>
                  <a:pt x="333375" y="809625"/>
                </a:cubicBezTo>
                <a:cubicBezTo>
                  <a:pt x="345108" y="792026"/>
                  <a:pt x="333012" y="805946"/>
                  <a:pt x="349250" y="796925"/>
                </a:cubicBezTo>
                <a:cubicBezTo>
                  <a:pt x="366340" y="787431"/>
                  <a:pt x="366255" y="786270"/>
                  <a:pt x="377825" y="774700"/>
                </a:cubicBezTo>
                <a:cubicBezTo>
                  <a:pt x="386588" y="748410"/>
                  <a:pt x="380462" y="761219"/>
                  <a:pt x="396875" y="736600"/>
                </a:cubicBezTo>
                <a:lnTo>
                  <a:pt x="403225" y="727075"/>
                </a:lnTo>
                <a:cubicBezTo>
                  <a:pt x="405342" y="723900"/>
                  <a:pt x="405955" y="718757"/>
                  <a:pt x="409575" y="717550"/>
                </a:cubicBezTo>
                <a:cubicBezTo>
                  <a:pt x="412750" y="716492"/>
                  <a:pt x="416174" y="716000"/>
                  <a:pt x="419100" y="714375"/>
                </a:cubicBezTo>
                <a:cubicBezTo>
                  <a:pt x="425771" y="710669"/>
                  <a:pt x="430910" y="704088"/>
                  <a:pt x="438150" y="701675"/>
                </a:cubicBezTo>
                <a:cubicBezTo>
                  <a:pt x="451295" y="697293"/>
                  <a:pt x="444890" y="700356"/>
                  <a:pt x="457200" y="692150"/>
                </a:cubicBezTo>
                <a:cubicBezTo>
                  <a:pt x="467783" y="676275"/>
                  <a:pt x="460375" y="684742"/>
                  <a:pt x="482600" y="669925"/>
                </a:cubicBezTo>
                <a:cubicBezTo>
                  <a:pt x="485775" y="667808"/>
                  <a:pt x="488505" y="664782"/>
                  <a:pt x="492125" y="663575"/>
                </a:cubicBezTo>
                <a:cubicBezTo>
                  <a:pt x="495300" y="662517"/>
                  <a:pt x="498724" y="662025"/>
                  <a:pt x="501650" y="660400"/>
                </a:cubicBezTo>
                <a:cubicBezTo>
                  <a:pt x="511718" y="654806"/>
                  <a:pt x="518620" y="646183"/>
                  <a:pt x="530225" y="644525"/>
                </a:cubicBezTo>
                <a:cubicBezTo>
                  <a:pt x="541797" y="642872"/>
                  <a:pt x="553508" y="642408"/>
                  <a:pt x="565150" y="641350"/>
                </a:cubicBezTo>
                <a:cubicBezTo>
                  <a:pt x="587589" y="636862"/>
                  <a:pt x="575905" y="639882"/>
                  <a:pt x="600075" y="631825"/>
                </a:cubicBezTo>
                <a:lnTo>
                  <a:pt x="609600" y="628650"/>
                </a:lnTo>
                <a:cubicBezTo>
                  <a:pt x="612182" y="620903"/>
                  <a:pt x="612970" y="615755"/>
                  <a:pt x="619125" y="609600"/>
                </a:cubicBezTo>
                <a:cubicBezTo>
                  <a:pt x="621823" y="606902"/>
                  <a:pt x="625237" y="604957"/>
                  <a:pt x="628650" y="603250"/>
                </a:cubicBezTo>
                <a:cubicBezTo>
                  <a:pt x="631643" y="601753"/>
                  <a:pt x="635000" y="601133"/>
                  <a:pt x="638175" y="600075"/>
                </a:cubicBezTo>
                <a:cubicBezTo>
                  <a:pt x="640554" y="592938"/>
                  <a:pt x="641956" y="583998"/>
                  <a:pt x="650875" y="581025"/>
                </a:cubicBezTo>
                <a:cubicBezTo>
                  <a:pt x="663089" y="576954"/>
                  <a:pt x="676761" y="578746"/>
                  <a:pt x="688975" y="574675"/>
                </a:cubicBezTo>
                <a:lnTo>
                  <a:pt x="698500" y="571500"/>
                </a:lnTo>
                <a:cubicBezTo>
                  <a:pt x="700617" y="568325"/>
                  <a:pt x="702152" y="564673"/>
                  <a:pt x="704850" y="561975"/>
                </a:cubicBezTo>
                <a:cubicBezTo>
                  <a:pt x="707548" y="559277"/>
                  <a:pt x="711862" y="558497"/>
                  <a:pt x="714375" y="555625"/>
                </a:cubicBezTo>
                <a:cubicBezTo>
                  <a:pt x="719401" y="549882"/>
                  <a:pt x="722842" y="542925"/>
                  <a:pt x="727075" y="536575"/>
                </a:cubicBezTo>
                <a:lnTo>
                  <a:pt x="739775" y="517525"/>
                </a:lnTo>
                <a:cubicBezTo>
                  <a:pt x="741892" y="514350"/>
                  <a:pt x="742950" y="510117"/>
                  <a:pt x="746125" y="508000"/>
                </a:cubicBezTo>
                <a:lnTo>
                  <a:pt x="755650" y="501650"/>
                </a:lnTo>
                <a:cubicBezTo>
                  <a:pt x="756708" y="498475"/>
                  <a:pt x="756734" y="494738"/>
                  <a:pt x="758825" y="492125"/>
                </a:cubicBezTo>
                <a:cubicBezTo>
                  <a:pt x="765591" y="483668"/>
                  <a:pt x="769592" y="487201"/>
                  <a:pt x="777875" y="482600"/>
                </a:cubicBezTo>
                <a:cubicBezTo>
                  <a:pt x="784546" y="478894"/>
                  <a:pt x="790575" y="474133"/>
                  <a:pt x="796925" y="469900"/>
                </a:cubicBezTo>
                <a:cubicBezTo>
                  <a:pt x="800100" y="467783"/>
                  <a:pt x="802830" y="464757"/>
                  <a:pt x="806450" y="463550"/>
                </a:cubicBezTo>
                <a:cubicBezTo>
                  <a:pt x="858279" y="446274"/>
                  <a:pt x="793245" y="466851"/>
                  <a:pt x="844550" y="454025"/>
                </a:cubicBezTo>
                <a:cubicBezTo>
                  <a:pt x="854862" y="451447"/>
                  <a:pt x="865502" y="445940"/>
                  <a:pt x="876300" y="444500"/>
                </a:cubicBezTo>
                <a:cubicBezTo>
                  <a:pt x="887887" y="442955"/>
                  <a:pt x="899558" y="442054"/>
                  <a:pt x="911225" y="441325"/>
                </a:cubicBezTo>
                <a:cubicBezTo>
                  <a:pt x="933432" y="439937"/>
                  <a:pt x="955675" y="439208"/>
                  <a:pt x="977900" y="438150"/>
                </a:cubicBezTo>
                <a:cubicBezTo>
                  <a:pt x="982392" y="436653"/>
                  <a:pt x="996138" y="431800"/>
                  <a:pt x="1000125" y="431800"/>
                </a:cubicBezTo>
                <a:cubicBezTo>
                  <a:pt x="1008658" y="431800"/>
                  <a:pt x="1017058" y="433917"/>
                  <a:pt x="1025525" y="434975"/>
                </a:cubicBezTo>
                <a:cubicBezTo>
                  <a:pt x="1054654" y="444685"/>
                  <a:pt x="1041710" y="441643"/>
                  <a:pt x="1101725" y="434975"/>
                </a:cubicBezTo>
                <a:cubicBezTo>
                  <a:pt x="1108378" y="434236"/>
                  <a:pt x="1120775" y="428625"/>
                  <a:pt x="1120775" y="428625"/>
                </a:cubicBezTo>
                <a:cubicBezTo>
                  <a:pt x="1122892" y="425450"/>
                  <a:pt x="1124427" y="421798"/>
                  <a:pt x="1127125" y="419100"/>
                </a:cubicBezTo>
                <a:cubicBezTo>
                  <a:pt x="1129823" y="416402"/>
                  <a:pt x="1134137" y="415622"/>
                  <a:pt x="1136650" y="412750"/>
                </a:cubicBezTo>
                <a:cubicBezTo>
                  <a:pt x="1141676" y="407007"/>
                  <a:pt x="1143954" y="399096"/>
                  <a:pt x="1149350" y="393700"/>
                </a:cubicBezTo>
                <a:cubicBezTo>
                  <a:pt x="1171098" y="371952"/>
                  <a:pt x="1160928" y="379631"/>
                  <a:pt x="1177925" y="368300"/>
                </a:cubicBezTo>
                <a:cubicBezTo>
                  <a:pt x="1185333" y="369358"/>
                  <a:pt x="1192812" y="370007"/>
                  <a:pt x="1200150" y="371475"/>
                </a:cubicBezTo>
                <a:cubicBezTo>
                  <a:pt x="1203432" y="372131"/>
                  <a:pt x="1207062" y="372559"/>
                  <a:pt x="1209675" y="374650"/>
                </a:cubicBezTo>
                <a:cubicBezTo>
                  <a:pt x="1212655" y="377034"/>
                  <a:pt x="1213908" y="381000"/>
                  <a:pt x="1216025" y="384175"/>
                </a:cubicBezTo>
                <a:cubicBezTo>
                  <a:pt x="1217026" y="399193"/>
                  <a:pt x="1217637" y="431899"/>
                  <a:pt x="1222375" y="450850"/>
                </a:cubicBezTo>
                <a:cubicBezTo>
                  <a:pt x="1223998" y="457344"/>
                  <a:pt x="1225012" y="464331"/>
                  <a:pt x="1228725" y="469900"/>
                </a:cubicBezTo>
                <a:cubicBezTo>
                  <a:pt x="1232958" y="476250"/>
                  <a:pt x="1234185" y="486537"/>
                  <a:pt x="1241425" y="488950"/>
                </a:cubicBezTo>
                <a:lnTo>
                  <a:pt x="1260475" y="495300"/>
                </a:lnTo>
                <a:cubicBezTo>
                  <a:pt x="1263650" y="496358"/>
                  <a:pt x="1266753" y="497663"/>
                  <a:pt x="1270000" y="498475"/>
                </a:cubicBezTo>
                <a:cubicBezTo>
                  <a:pt x="1274233" y="499533"/>
                  <a:pt x="1278520" y="500396"/>
                  <a:pt x="1282700" y="501650"/>
                </a:cubicBezTo>
                <a:cubicBezTo>
                  <a:pt x="1289111" y="503573"/>
                  <a:pt x="1301750" y="508000"/>
                  <a:pt x="1301750" y="508000"/>
                </a:cubicBezTo>
                <a:cubicBezTo>
                  <a:pt x="1309158" y="506942"/>
                  <a:pt x="1316807" y="506975"/>
                  <a:pt x="1323975" y="504825"/>
                </a:cubicBezTo>
                <a:cubicBezTo>
                  <a:pt x="1336568" y="501047"/>
                  <a:pt x="1332044" y="498211"/>
                  <a:pt x="1336675" y="488950"/>
                </a:cubicBezTo>
                <a:cubicBezTo>
                  <a:pt x="1341095" y="480109"/>
                  <a:pt x="1345528" y="476922"/>
                  <a:pt x="1352550" y="469900"/>
                </a:cubicBezTo>
                <a:cubicBezTo>
                  <a:pt x="1355132" y="462153"/>
                  <a:pt x="1355920" y="457005"/>
                  <a:pt x="1362075" y="450850"/>
                </a:cubicBezTo>
                <a:cubicBezTo>
                  <a:pt x="1369622" y="443303"/>
                  <a:pt x="1381219" y="441294"/>
                  <a:pt x="1390650" y="438150"/>
                </a:cubicBezTo>
                <a:lnTo>
                  <a:pt x="1400175" y="434975"/>
                </a:lnTo>
                <a:lnTo>
                  <a:pt x="1419225" y="428625"/>
                </a:lnTo>
                <a:lnTo>
                  <a:pt x="1428750" y="425450"/>
                </a:lnTo>
                <a:cubicBezTo>
                  <a:pt x="1438813" y="410356"/>
                  <a:pt x="1433893" y="419545"/>
                  <a:pt x="1441450" y="396875"/>
                </a:cubicBezTo>
                <a:lnTo>
                  <a:pt x="1444625" y="387350"/>
                </a:lnTo>
                <a:cubicBezTo>
                  <a:pt x="1445533" y="376459"/>
                  <a:pt x="1445253" y="343546"/>
                  <a:pt x="1454150" y="330200"/>
                </a:cubicBezTo>
                <a:cubicBezTo>
                  <a:pt x="1456267" y="327025"/>
                  <a:pt x="1457802" y="323373"/>
                  <a:pt x="1460500" y="320675"/>
                </a:cubicBezTo>
                <a:cubicBezTo>
                  <a:pt x="1466655" y="314520"/>
                  <a:pt x="1471803" y="313732"/>
                  <a:pt x="1479550" y="311150"/>
                </a:cubicBezTo>
                <a:cubicBezTo>
                  <a:pt x="1473502" y="293007"/>
                  <a:pt x="1481364" y="308126"/>
                  <a:pt x="1466850" y="298450"/>
                </a:cubicBezTo>
                <a:cubicBezTo>
                  <a:pt x="1463114" y="295959"/>
                  <a:pt x="1461224" y="291153"/>
                  <a:pt x="1457325" y="288925"/>
                </a:cubicBezTo>
                <a:cubicBezTo>
                  <a:pt x="1453536" y="286760"/>
                  <a:pt x="1448821" y="286949"/>
                  <a:pt x="1444625" y="285750"/>
                </a:cubicBezTo>
                <a:cubicBezTo>
                  <a:pt x="1435909" y="283260"/>
                  <a:pt x="1432835" y="282275"/>
                  <a:pt x="1425575" y="276225"/>
                </a:cubicBezTo>
                <a:cubicBezTo>
                  <a:pt x="1398763" y="253881"/>
                  <a:pt x="1438751" y="283051"/>
                  <a:pt x="1403350" y="247650"/>
                </a:cubicBezTo>
                <a:cubicBezTo>
                  <a:pt x="1388429" y="232729"/>
                  <a:pt x="1396316" y="241861"/>
                  <a:pt x="1381125" y="219075"/>
                </a:cubicBezTo>
                <a:lnTo>
                  <a:pt x="1374775" y="209550"/>
                </a:lnTo>
                <a:cubicBezTo>
                  <a:pt x="1372658" y="206375"/>
                  <a:pt x="1369632" y="203645"/>
                  <a:pt x="1368425" y="200025"/>
                </a:cubicBezTo>
                <a:lnTo>
                  <a:pt x="1362075" y="180975"/>
                </a:lnTo>
                <a:cubicBezTo>
                  <a:pt x="1361017" y="177800"/>
                  <a:pt x="1359556" y="174732"/>
                  <a:pt x="1358900" y="171450"/>
                </a:cubicBezTo>
                <a:lnTo>
                  <a:pt x="1355725" y="155575"/>
                </a:lnTo>
                <a:cubicBezTo>
                  <a:pt x="1351936" y="110107"/>
                  <a:pt x="1350553" y="115217"/>
                  <a:pt x="1355725" y="63500"/>
                </a:cubicBezTo>
                <a:cubicBezTo>
                  <a:pt x="1356058" y="60170"/>
                  <a:pt x="1356533" y="56342"/>
                  <a:pt x="1358900" y="53975"/>
                </a:cubicBezTo>
                <a:cubicBezTo>
                  <a:pt x="1383474" y="29401"/>
                  <a:pt x="1369509" y="48081"/>
                  <a:pt x="1387475" y="38100"/>
                </a:cubicBezTo>
                <a:cubicBezTo>
                  <a:pt x="1394146" y="34394"/>
                  <a:pt x="1399285" y="27813"/>
                  <a:pt x="1406525" y="25400"/>
                </a:cubicBezTo>
                <a:cubicBezTo>
                  <a:pt x="1409700" y="24342"/>
                  <a:pt x="1413057" y="23722"/>
                  <a:pt x="1416050" y="22225"/>
                </a:cubicBezTo>
                <a:cubicBezTo>
                  <a:pt x="1419463" y="20518"/>
                  <a:pt x="1421888" y="16858"/>
                  <a:pt x="1425575" y="15875"/>
                </a:cubicBezTo>
                <a:cubicBezTo>
                  <a:pt x="1438015" y="12558"/>
                  <a:pt x="1451461" y="13596"/>
                  <a:pt x="1463675" y="9525"/>
                </a:cubicBezTo>
                <a:lnTo>
                  <a:pt x="1482725" y="3175"/>
                </a:lnTo>
                <a:lnTo>
                  <a:pt x="1492250" y="0"/>
                </a:lnTo>
                <a:cubicBezTo>
                  <a:pt x="1495425" y="2117"/>
                  <a:pt x="1498362" y="4643"/>
                  <a:pt x="1501775" y="6350"/>
                </a:cubicBezTo>
                <a:cubicBezTo>
                  <a:pt x="1504768" y="7847"/>
                  <a:pt x="1508687" y="7434"/>
                  <a:pt x="1511300" y="9525"/>
                </a:cubicBezTo>
                <a:cubicBezTo>
                  <a:pt x="1514280" y="11909"/>
                  <a:pt x="1514778" y="16537"/>
                  <a:pt x="1517650" y="19050"/>
                </a:cubicBezTo>
                <a:cubicBezTo>
                  <a:pt x="1523393" y="24076"/>
                  <a:pt x="1531304" y="26354"/>
                  <a:pt x="1536700" y="31750"/>
                </a:cubicBezTo>
                <a:lnTo>
                  <a:pt x="1546225" y="41275"/>
                </a:lnTo>
              </a:path>
            </a:pathLst>
          </a:custGeom>
          <a:ln w="6350" cmpd="sng">
            <a:solidFill>
              <a:schemeClr val="bg1"/>
            </a:solidFill>
            <a:prstDash val="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042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</TotalTime>
  <Words>55</Words>
  <Application>Microsoft Macintosh PowerPoint</Application>
  <PresentationFormat>A4 Paper (210x297 mm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ept. de Pathologi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y Palmer</dc:creator>
  <cp:lastModifiedBy>Gaby Palmer</cp:lastModifiedBy>
  <cp:revision>48</cp:revision>
  <dcterms:created xsi:type="dcterms:W3CDTF">2019-06-06T13:32:21Z</dcterms:created>
  <dcterms:modified xsi:type="dcterms:W3CDTF">2019-10-10T11:54:17Z</dcterms:modified>
</cp:coreProperties>
</file>